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wmf" ContentType="image/x-wmf"/>
  <Override PartName="/ppt/media/image4.wmf" ContentType="image/x-wmf"/>
  <Override PartName="/ppt/media/image5.jpeg" ContentType="image/jpeg"/>
  <Override PartName="/ppt/media/image10.jpeg" ContentType="image/jpeg"/>
  <Override PartName="/ppt/media/image6.jpeg" ContentType="image/jpeg"/>
  <Override PartName="/ppt/media/image8.png" ContentType="image/png"/>
  <Override PartName="/ppt/media/image7.png" ContentType="image/png"/>
  <Override PartName="/ppt/media/image9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</p:sldIdLst>
  <p:sldSz cx="15606713" cy="96012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11FBBF-F489-4C09-90CF-F8C5D3670DD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1073160" y="510840"/>
            <a:ext cx="13460400" cy="1855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170000"/>
                <a:tab algn="l" pos="2340000"/>
                <a:tab algn="l" pos="3510000"/>
                <a:tab algn="l" pos="4680000"/>
                <a:tab algn="l" pos="5850000"/>
                <a:tab algn="l" pos="7020000"/>
                <a:tab algn="l" pos="8190000"/>
                <a:tab algn="l" pos="9360000"/>
                <a:tab algn="l" pos="10530000"/>
              </a:tabLst>
            </a:pPr>
            <a:endParaRPr b="0" lang="en-US" sz="56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1073160" y="2556000"/>
            <a:ext cx="13460400" cy="2905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276"/>
              </a:spcBef>
              <a:buNone/>
              <a:tabLst>
                <a:tab algn="l" pos="1170000"/>
                <a:tab algn="l" pos="2340000"/>
                <a:tab algn="l" pos="3510000"/>
                <a:tab algn="l" pos="4680000"/>
                <a:tab algn="l" pos="5850000"/>
                <a:tab algn="l" pos="7020000"/>
                <a:tab algn="l" pos="8190000"/>
                <a:tab algn="l" pos="9360000"/>
                <a:tab algn="l" pos="10530000"/>
              </a:tabLst>
            </a:pPr>
            <a:endParaRPr b="0" lang="en-US" sz="3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1073160" y="5737680"/>
            <a:ext cx="13460400" cy="2905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276"/>
              </a:spcBef>
              <a:buNone/>
              <a:tabLst>
                <a:tab algn="l" pos="1170000"/>
                <a:tab algn="l" pos="2340000"/>
                <a:tab algn="l" pos="3510000"/>
                <a:tab algn="l" pos="4680000"/>
                <a:tab algn="l" pos="5850000"/>
                <a:tab algn="l" pos="7020000"/>
                <a:tab algn="l" pos="8190000"/>
                <a:tab algn="l" pos="9360000"/>
                <a:tab algn="l" pos="10530000"/>
              </a:tabLst>
            </a:pPr>
            <a:endParaRPr b="0" lang="en-US" sz="3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357FBA-9B14-423A-BCB7-D6E3D78922C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1073160" y="510840"/>
            <a:ext cx="13460400" cy="1855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170000"/>
                <a:tab algn="l" pos="2340000"/>
                <a:tab algn="l" pos="3510000"/>
                <a:tab algn="l" pos="4680000"/>
                <a:tab algn="l" pos="5850000"/>
                <a:tab algn="l" pos="7020000"/>
                <a:tab algn="l" pos="8190000"/>
                <a:tab algn="l" pos="9360000"/>
                <a:tab algn="l" pos="10530000"/>
              </a:tabLst>
            </a:pPr>
            <a:endParaRPr b="0" lang="en-US" sz="56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1073160" y="2556000"/>
            <a:ext cx="6568560" cy="2905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276"/>
              </a:spcBef>
              <a:buNone/>
              <a:tabLst>
                <a:tab algn="l" pos="1170000"/>
                <a:tab algn="l" pos="2340000"/>
                <a:tab algn="l" pos="3510000"/>
                <a:tab algn="l" pos="4680000"/>
                <a:tab algn="l" pos="5850000"/>
                <a:tab algn="l" pos="7020000"/>
                <a:tab algn="l" pos="8190000"/>
                <a:tab algn="l" pos="9360000"/>
                <a:tab algn="l" pos="10530000"/>
              </a:tabLst>
            </a:pPr>
            <a:endParaRPr b="0" lang="en-US" sz="3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7970400" y="2556000"/>
            <a:ext cx="6568560" cy="2905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276"/>
              </a:spcBef>
              <a:buNone/>
              <a:tabLst>
                <a:tab algn="l" pos="1170000"/>
                <a:tab algn="l" pos="2340000"/>
                <a:tab algn="l" pos="3510000"/>
                <a:tab algn="l" pos="4680000"/>
                <a:tab algn="l" pos="5850000"/>
                <a:tab algn="l" pos="7020000"/>
                <a:tab algn="l" pos="8190000"/>
                <a:tab algn="l" pos="9360000"/>
                <a:tab algn="l" pos="10530000"/>
              </a:tabLst>
            </a:pPr>
            <a:endParaRPr b="0" lang="en-US" sz="3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1073160" y="5737680"/>
            <a:ext cx="6568560" cy="2905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276"/>
              </a:spcBef>
              <a:buNone/>
              <a:tabLst>
                <a:tab algn="l" pos="1170000"/>
                <a:tab algn="l" pos="2340000"/>
                <a:tab algn="l" pos="3510000"/>
                <a:tab algn="l" pos="4680000"/>
                <a:tab algn="l" pos="5850000"/>
                <a:tab algn="l" pos="7020000"/>
                <a:tab algn="l" pos="8190000"/>
                <a:tab algn="l" pos="9360000"/>
                <a:tab algn="l" pos="10530000"/>
              </a:tabLst>
            </a:pPr>
            <a:endParaRPr b="0" lang="en-US" sz="3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7970400" y="5737680"/>
            <a:ext cx="6568560" cy="2905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276"/>
              </a:spcBef>
              <a:buNone/>
              <a:tabLst>
                <a:tab algn="l" pos="1170000"/>
                <a:tab algn="l" pos="2340000"/>
                <a:tab algn="l" pos="3510000"/>
                <a:tab algn="l" pos="4680000"/>
                <a:tab algn="l" pos="5850000"/>
                <a:tab algn="l" pos="7020000"/>
                <a:tab algn="l" pos="8190000"/>
                <a:tab algn="l" pos="9360000"/>
                <a:tab algn="l" pos="10530000"/>
              </a:tabLst>
            </a:pPr>
            <a:endParaRPr b="0" lang="en-US" sz="3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1D1F11-C32D-451E-8790-FFF2F2F8ECA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1073160" y="510840"/>
            <a:ext cx="13460400" cy="1855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170000"/>
                <a:tab algn="l" pos="2340000"/>
                <a:tab algn="l" pos="3510000"/>
                <a:tab algn="l" pos="4680000"/>
                <a:tab algn="l" pos="5850000"/>
                <a:tab algn="l" pos="7020000"/>
                <a:tab algn="l" pos="8190000"/>
                <a:tab algn="l" pos="9360000"/>
                <a:tab algn="l" pos="10530000"/>
              </a:tabLst>
            </a:pPr>
            <a:endParaRPr b="0" lang="en-US" sz="56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1073160" y="2556000"/>
            <a:ext cx="4334040" cy="2905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276"/>
              </a:spcBef>
              <a:buNone/>
              <a:tabLst>
                <a:tab algn="l" pos="1170000"/>
                <a:tab algn="l" pos="2340000"/>
                <a:tab algn="l" pos="3510000"/>
                <a:tab algn="l" pos="4680000"/>
                <a:tab algn="l" pos="5850000"/>
                <a:tab algn="l" pos="7020000"/>
                <a:tab algn="l" pos="8190000"/>
                <a:tab algn="l" pos="9360000"/>
                <a:tab algn="l" pos="10530000"/>
              </a:tabLst>
            </a:pPr>
            <a:endParaRPr b="0" lang="en-US" sz="3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5624280" y="2556000"/>
            <a:ext cx="4334040" cy="2905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276"/>
              </a:spcBef>
              <a:buNone/>
              <a:tabLst>
                <a:tab algn="l" pos="1170000"/>
                <a:tab algn="l" pos="2340000"/>
                <a:tab algn="l" pos="3510000"/>
                <a:tab algn="l" pos="4680000"/>
                <a:tab algn="l" pos="5850000"/>
                <a:tab algn="l" pos="7020000"/>
                <a:tab algn="l" pos="8190000"/>
                <a:tab algn="l" pos="9360000"/>
                <a:tab algn="l" pos="10530000"/>
              </a:tabLst>
            </a:pPr>
            <a:endParaRPr b="0" lang="en-US" sz="3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10175400" y="2556000"/>
            <a:ext cx="4334040" cy="2905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276"/>
              </a:spcBef>
              <a:buNone/>
              <a:tabLst>
                <a:tab algn="l" pos="1170000"/>
                <a:tab algn="l" pos="2340000"/>
                <a:tab algn="l" pos="3510000"/>
                <a:tab algn="l" pos="4680000"/>
                <a:tab algn="l" pos="5850000"/>
                <a:tab algn="l" pos="7020000"/>
                <a:tab algn="l" pos="8190000"/>
                <a:tab algn="l" pos="9360000"/>
                <a:tab algn="l" pos="10530000"/>
              </a:tabLst>
            </a:pPr>
            <a:endParaRPr b="0" lang="en-US" sz="3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1073160" y="5737680"/>
            <a:ext cx="4334040" cy="2905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276"/>
              </a:spcBef>
              <a:buNone/>
              <a:tabLst>
                <a:tab algn="l" pos="1170000"/>
                <a:tab algn="l" pos="2340000"/>
                <a:tab algn="l" pos="3510000"/>
                <a:tab algn="l" pos="4680000"/>
                <a:tab algn="l" pos="5850000"/>
                <a:tab algn="l" pos="7020000"/>
                <a:tab algn="l" pos="8190000"/>
                <a:tab algn="l" pos="9360000"/>
                <a:tab algn="l" pos="10530000"/>
              </a:tabLst>
            </a:pPr>
            <a:endParaRPr b="0" lang="en-US" sz="3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5624280" y="5737680"/>
            <a:ext cx="4334040" cy="2905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276"/>
              </a:spcBef>
              <a:buNone/>
              <a:tabLst>
                <a:tab algn="l" pos="1170000"/>
                <a:tab algn="l" pos="2340000"/>
                <a:tab algn="l" pos="3510000"/>
                <a:tab algn="l" pos="4680000"/>
                <a:tab algn="l" pos="5850000"/>
                <a:tab algn="l" pos="7020000"/>
                <a:tab algn="l" pos="8190000"/>
                <a:tab algn="l" pos="9360000"/>
                <a:tab algn="l" pos="10530000"/>
              </a:tabLst>
            </a:pPr>
            <a:endParaRPr b="0" lang="en-US" sz="3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10175400" y="5737680"/>
            <a:ext cx="4334040" cy="2905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276"/>
              </a:spcBef>
              <a:buNone/>
              <a:tabLst>
                <a:tab algn="l" pos="1170000"/>
                <a:tab algn="l" pos="2340000"/>
                <a:tab algn="l" pos="3510000"/>
                <a:tab algn="l" pos="4680000"/>
                <a:tab algn="l" pos="5850000"/>
                <a:tab algn="l" pos="7020000"/>
                <a:tab algn="l" pos="8190000"/>
                <a:tab algn="l" pos="9360000"/>
                <a:tab algn="l" pos="10530000"/>
              </a:tabLst>
            </a:pPr>
            <a:endParaRPr b="0" lang="en-US" sz="3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4D9724-5E2F-4DE7-B038-B998982F909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1073160" y="510840"/>
            <a:ext cx="13460400" cy="1855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170000"/>
                <a:tab algn="l" pos="2340000"/>
                <a:tab algn="l" pos="3510000"/>
                <a:tab algn="l" pos="4680000"/>
                <a:tab algn="l" pos="5850000"/>
                <a:tab algn="l" pos="7020000"/>
                <a:tab algn="l" pos="8190000"/>
                <a:tab algn="l" pos="9360000"/>
                <a:tab algn="l" pos="10530000"/>
              </a:tabLst>
            </a:pPr>
            <a:endParaRPr b="0" lang="en-US" sz="56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1073160" y="2556000"/>
            <a:ext cx="13460400" cy="6091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276"/>
              </a:spcBef>
              <a:buNone/>
              <a:tabLst>
                <a:tab algn="l" pos="0"/>
                <a:tab algn="l" pos="1170000"/>
                <a:tab algn="l" pos="2340000"/>
                <a:tab algn="l" pos="3510000"/>
                <a:tab algn="l" pos="4680000"/>
                <a:tab algn="l" pos="5850000"/>
                <a:tab algn="l" pos="7020000"/>
                <a:tab algn="l" pos="8190000"/>
                <a:tab algn="l" pos="9360000"/>
                <a:tab algn="l" pos="10530000"/>
              </a:tabLst>
            </a:pPr>
            <a:endParaRPr b="0" lang="en-US" sz="3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241525-109C-4AAF-B3EE-75546AE7DFF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1073160" y="510840"/>
            <a:ext cx="13460400" cy="1855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170000"/>
                <a:tab algn="l" pos="2340000"/>
                <a:tab algn="l" pos="3510000"/>
                <a:tab algn="l" pos="4680000"/>
                <a:tab algn="l" pos="5850000"/>
                <a:tab algn="l" pos="7020000"/>
                <a:tab algn="l" pos="8190000"/>
                <a:tab algn="l" pos="9360000"/>
                <a:tab algn="l" pos="10530000"/>
              </a:tabLst>
            </a:pPr>
            <a:endParaRPr b="0" lang="en-US" sz="56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1073160" y="2556000"/>
            <a:ext cx="13460400" cy="609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276"/>
              </a:spcBef>
              <a:buNone/>
              <a:tabLst>
                <a:tab algn="l" pos="1170000"/>
                <a:tab algn="l" pos="2340000"/>
                <a:tab algn="l" pos="3510000"/>
                <a:tab algn="l" pos="4680000"/>
                <a:tab algn="l" pos="5850000"/>
                <a:tab algn="l" pos="7020000"/>
                <a:tab algn="l" pos="8190000"/>
                <a:tab algn="l" pos="9360000"/>
                <a:tab algn="l" pos="10530000"/>
              </a:tabLst>
            </a:pPr>
            <a:endParaRPr b="0" lang="en-US" sz="3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9EB987-3319-4E45-9152-55036DFC199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1073160" y="510840"/>
            <a:ext cx="13460400" cy="1855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170000"/>
                <a:tab algn="l" pos="2340000"/>
                <a:tab algn="l" pos="3510000"/>
                <a:tab algn="l" pos="4680000"/>
                <a:tab algn="l" pos="5850000"/>
                <a:tab algn="l" pos="7020000"/>
                <a:tab algn="l" pos="8190000"/>
                <a:tab algn="l" pos="9360000"/>
                <a:tab algn="l" pos="10530000"/>
              </a:tabLst>
            </a:pPr>
            <a:endParaRPr b="0" lang="en-US" sz="56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1073160" y="2556000"/>
            <a:ext cx="6568560" cy="609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276"/>
              </a:spcBef>
              <a:buNone/>
              <a:tabLst>
                <a:tab algn="l" pos="1170000"/>
                <a:tab algn="l" pos="2340000"/>
                <a:tab algn="l" pos="3510000"/>
                <a:tab algn="l" pos="4680000"/>
                <a:tab algn="l" pos="5850000"/>
                <a:tab algn="l" pos="7020000"/>
                <a:tab algn="l" pos="8190000"/>
                <a:tab algn="l" pos="9360000"/>
                <a:tab algn="l" pos="10530000"/>
              </a:tabLst>
            </a:pPr>
            <a:endParaRPr b="0" lang="en-US" sz="3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7970400" y="2556000"/>
            <a:ext cx="6568560" cy="609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276"/>
              </a:spcBef>
              <a:buNone/>
              <a:tabLst>
                <a:tab algn="l" pos="1170000"/>
                <a:tab algn="l" pos="2340000"/>
                <a:tab algn="l" pos="3510000"/>
                <a:tab algn="l" pos="4680000"/>
                <a:tab algn="l" pos="5850000"/>
                <a:tab algn="l" pos="7020000"/>
                <a:tab algn="l" pos="8190000"/>
                <a:tab algn="l" pos="9360000"/>
                <a:tab algn="l" pos="10530000"/>
              </a:tabLst>
            </a:pPr>
            <a:endParaRPr b="0" lang="en-US" sz="3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8968D7-D40F-4654-BB99-0BBCBB33BAA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1073160" y="510840"/>
            <a:ext cx="13460400" cy="1855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170000"/>
                <a:tab algn="l" pos="2340000"/>
                <a:tab algn="l" pos="3510000"/>
                <a:tab algn="l" pos="4680000"/>
                <a:tab algn="l" pos="5850000"/>
                <a:tab algn="l" pos="7020000"/>
                <a:tab algn="l" pos="8190000"/>
                <a:tab algn="l" pos="9360000"/>
                <a:tab algn="l" pos="10530000"/>
              </a:tabLst>
            </a:pPr>
            <a:endParaRPr b="0" lang="en-US" sz="56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563301-1D64-455D-84E9-A98FB970D2E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1073160" y="510840"/>
            <a:ext cx="13460400" cy="8603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276"/>
              </a:spcBef>
              <a:tabLst>
                <a:tab algn="l" pos="0"/>
                <a:tab algn="l" pos="1170000"/>
                <a:tab algn="l" pos="2340000"/>
                <a:tab algn="l" pos="3510000"/>
                <a:tab algn="l" pos="4680000"/>
                <a:tab algn="l" pos="5850000"/>
                <a:tab algn="l" pos="7020000"/>
                <a:tab algn="l" pos="8190000"/>
                <a:tab algn="l" pos="9360000"/>
                <a:tab algn="l" pos="10530000"/>
              </a:tabLst>
            </a:pPr>
            <a:endParaRPr b="0" lang="en-US" sz="3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EB1227-DE57-477E-ACD7-E7F5416152A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1073160" y="510840"/>
            <a:ext cx="13460400" cy="1855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170000"/>
                <a:tab algn="l" pos="2340000"/>
                <a:tab algn="l" pos="3510000"/>
                <a:tab algn="l" pos="4680000"/>
                <a:tab algn="l" pos="5850000"/>
                <a:tab algn="l" pos="7020000"/>
                <a:tab algn="l" pos="8190000"/>
                <a:tab algn="l" pos="9360000"/>
                <a:tab algn="l" pos="10530000"/>
              </a:tabLst>
            </a:pPr>
            <a:endParaRPr b="0" lang="en-US" sz="56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1073160" y="2556000"/>
            <a:ext cx="6568560" cy="2905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276"/>
              </a:spcBef>
              <a:buNone/>
              <a:tabLst>
                <a:tab algn="l" pos="1170000"/>
                <a:tab algn="l" pos="2340000"/>
                <a:tab algn="l" pos="3510000"/>
                <a:tab algn="l" pos="4680000"/>
                <a:tab algn="l" pos="5850000"/>
                <a:tab algn="l" pos="7020000"/>
                <a:tab algn="l" pos="8190000"/>
                <a:tab algn="l" pos="9360000"/>
                <a:tab algn="l" pos="10530000"/>
              </a:tabLst>
            </a:pPr>
            <a:endParaRPr b="0" lang="en-US" sz="3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7970400" y="2556000"/>
            <a:ext cx="6568560" cy="609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276"/>
              </a:spcBef>
              <a:buNone/>
              <a:tabLst>
                <a:tab algn="l" pos="1170000"/>
                <a:tab algn="l" pos="2340000"/>
                <a:tab algn="l" pos="3510000"/>
                <a:tab algn="l" pos="4680000"/>
                <a:tab algn="l" pos="5850000"/>
                <a:tab algn="l" pos="7020000"/>
                <a:tab algn="l" pos="8190000"/>
                <a:tab algn="l" pos="9360000"/>
                <a:tab algn="l" pos="10530000"/>
              </a:tabLst>
            </a:pPr>
            <a:endParaRPr b="0" lang="en-US" sz="3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1073160" y="5737680"/>
            <a:ext cx="6568560" cy="2905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276"/>
              </a:spcBef>
              <a:buNone/>
              <a:tabLst>
                <a:tab algn="l" pos="1170000"/>
                <a:tab algn="l" pos="2340000"/>
                <a:tab algn="l" pos="3510000"/>
                <a:tab algn="l" pos="4680000"/>
                <a:tab algn="l" pos="5850000"/>
                <a:tab algn="l" pos="7020000"/>
                <a:tab algn="l" pos="8190000"/>
                <a:tab algn="l" pos="9360000"/>
                <a:tab algn="l" pos="10530000"/>
              </a:tabLst>
            </a:pPr>
            <a:endParaRPr b="0" lang="en-US" sz="3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E2881B-158B-41B5-8D1A-FE7E70EEE3A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1073160" y="510840"/>
            <a:ext cx="13460400" cy="1855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170000"/>
                <a:tab algn="l" pos="2340000"/>
                <a:tab algn="l" pos="3510000"/>
                <a:tab algn="l" pos="4680000"/>
                <a:tab algn="l" pos="5850000"/>
                <a:tab algn="l" pos="7020000"/>
                <a:tab algn="l" pos="8190000"/>
                <a:tab algn="l" pos="9360000"/>
                <a:tab algn="l" pos="10530000"/>
              </a:tabLst>
            </a:pPr>
            <a:endParaRPr b="0" lang="en-US" sz="56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1073160" y="2556000"/>
            <a:ext cx="6568560" cy="609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276"/>
              </a:spcBef>
              <a:buNone/>
              <a:tabLst>
                <a:tab algn="l" pos="1170000"/>
                <a:tab algn="l" pos="2340000"/>
                <a:tab algn="l" pos="3510000"/>
                <a:tab algn="l" pos="4680000"/>
                <a:tab algn="l" pos="5850000"/>
                <a:tab algn="l" pos="7020000"/>
                <a:tab algn="l" pos="8190000"/>
                <a:tab algn="l" pos="9360000"/>
                <a:tab algn="l" pos="10530000"/>
              </a:tabLst>
            </a:pPr>
            <a:endParaRPr b="0" lang="en-US" sz="3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7970400" y="2556000"/>
            <a:ext cx="6568560" cy="2905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276"/>
              </a:spcBef>
              <a:buNone/>
              <a:tabLst>
                <a:tab algn="l" pos="1170000"/>
                <a:tab algn="l" pos="2340000"/>
                <a:tab algn="l" pos="3510000"/>
                <a:tab algn="l" pos="4680000"/>
                <a:tab algn="l" pos="5850000"/>
                <a:tab algn="l" pos="7020000"/>
                <a:tab algn="l" pos="8190000"/>
                <a:tab algn="l" pos="9360000"/>
                <a:tab algn="l" pos="10530000"/>
              </a:tabLst>
            </a:pPr>
            <a:endParaRPr b="0" lang="en-US" sz="3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7970400" y="5737680"/>
            <a:ext cx="6568560" cy="2905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276"/>
              </a:spcBef>
              <a:buNone/>
              <a:tabLst>
                <a:tab algn="l" pos="1170000"/>
                <a:tab algn="l" pos="2340000"/>
                <a:tab algn="l" pos="3510000"/>
                <a:tab algn="l" pos="4680000"/>
                <a:tab algn="l" pos="5850000"/>
                <a:tab algn="l" pos="7020000"/>
                <a:tab algn="l" pos="8190000"/>
                <a:tab algn="l" pos="9360000"/>
                <a:tab algn="l" pos="10530000"/>
              </a:tabLst>
            </a:pPr>
            <a:endParaRPr b="0" lang="en-US" sz="3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E102E6-A42E-479B-AEA0-99308641A60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1073160" y="510840"/>
            <a:ext cx="13460400" cy="1855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170000"/>
                <a:tab algn="l" pos="2340000"/>
                <a:tab algn="l" pos="3510000"/>
                <a:tab algn="l" pos="4680000"/>
                <a:tab algn="l" pos="5850000"/>
                <a:tab algn="l" pos="7020000"/>
                <a:tab algn="l" pos="8190000"/>
                <a:tab algn="l" pos="9360000"/>
                <a:tab algn="l" pos="10530000"/>
              </a:tabLst>
            </a:pPr>
            <a:endParaRPr b="0" lang="en-US" sz="56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1073160" y="2556000"/>
            <a:ext cx="6568560" cy="2905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276"/>
              </a:spcBef>
              <a:buNone/>
              <a:tabLst>
                <a:tab algn="l" pos="1170000"/>
                <a:tab algn="l" pos="2340000"/>
                <a:tab algn="l" pos="3510000"/>
                <a:tab algn="l" pos="4680000"/>
                <a:tab algn="l" pos="5850000"/>
                <a:tab algn="l" pos="7020000"/>
                <a:tab algn="l" pos="8190000"/>
                <a:tab algn="l" pos="9360000"/>
                <a:tab algn="l" pos="10530000"/>
              </a:tabLst>
            </a:pPr>
            <a:endParaRPr b="0" lang="en-US" sz="3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7970400" y="2556000"/>
            <a:ext cx="6568560" cy="2905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276"/>
              </a:spcBef>
              <a:buNone/>
              <a:tabLst>
                <a:tab algn="l" pos="1170000"/>
                <a:tab algn="l" pos="2340000"/>
                <a:tab algn="l" pos="3510000"/>
                <a:tab algn="l" pos="4680000"/>
                <a:tab algn="l" pos="5850000"/>
                <a:tab algn="l" pos="7020000"/>
                <a:tab algn="l" pos="8190000"/>
                <a:tab algn="l" pos="9360000"/>
                <a:tab algn="l" pos="10530000"/>
              </a:tabLst>
            </a:pPr>
            <a:endParaRPr b="0" lang="en-US" sz="3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1073160" y="5737680"/>
            <a:ext cx="13460400" cy="2905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276"/>
              </a:spcBef>
              <a:buNone/>
              <a:tabLst>
                <a:tab algn="l" pos="1170000"/>
                <a:tab algn="l" pos="2340000"/>
                <a:tab algn="l" pos="3510000"/>
                <a:tab algn="l" pos="4680000"/>
                <a:tab algn="l" pos="5850000"/>
                <a:tab algn="l" pos="7020000"/>
                <a:tab algn="l" pos="8190000"/>
                <a:tab algn="l" pos="9360000"/>
                <a:tab algn="l" pos="10530000"/>
              </a:tabLst>
            </a:pPr>
            <a:endParaRPr b="0" lang="en-US" sz="3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AEBAA4-1866-4C2A-8A98-8744BDC4577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1073160" y="510840"/>
            <a:ext cx="13460400" cy="1855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170000"/>
                <a:tab algn="l" pos="2340000"/>
                <a:tab algn="l" pos="3510000"/>
                <a:tab algn="l" pos="4680000"/>
                <a:tab algn="l" pos="5850000"/>
                <a:tab algn="l" pos="7020000"/>
                <a:tab algn="l" pos="8190000"/>
                <a:tab algn="l" pos="9360000"/>
                <a:tab algn="l" pos="10530000"/>
              </a:tabLst>
            </a:pPr>
            <a:r>
              <a:rPr b="0" lang="en-US" sz="56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56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1073160" y="2556000"/>
            <a:ext cx="13460400" cy="609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91960" indent="-291960">
              <a:lnSpc>
                <a:spcPct val="90000"/>
              </a:lnSpc>
              <a:spcBef>
                <a:spcPts val="1276"/>
              </a:spcBef>
              <a:buClr>
                <a:srgbClr val="000000"/>
              </a:buClr>
              <a:buFont typeface="Arial"/>
              <a:buChar char="•"/>
              <a:tabLst>
                <a:tab algn="l" pos="1170000"/>
                <a:tab algn="l" pos="2340000"/>
                <a:tab algn="l" pos="3510000"/>
                <a:tab algn="l" pos="4680000"/>
                <a:tab algn="l" pos="5850000"/>
                <a:tab algn="l" pos="7020000"/>
                <a:tab algn="l" pos="8190000"/>
                <a:tab algn="l" pos="9360000"/>
                <a:tab algn="l" pos="10530000"/>
              </a:tabLst>
            </a:pPr>
            <a:r>
              <a:rPr b="0" lang="en-US" sz="35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500" spc="-1" strike="noStrike">
              <a:solidFill>
                <a:srgbClr val="000000"/>
              </a:solidFill>
              <a:latin typeface="Calibri"/>
            </a:endParaRPr>
          </a:p>
          <a:p>
            <a:pPr lvl="1" marL="878040" indent="-292320">
              <a:lnSpc>
                <a:spcPct val="90000"/>
              </a:lnSpc>
              <a:spcBef>
                <a:spcPts val="1276"/>
              </a:spcBef>
              <a:buClr>
                <a:srgbClr val="000000"/>
              </a:buClr>
              <a:buFont typeface="Arial"/>
              <a:buChar char="•"/>
              <a:tabLst>
                <a:tab algn="l" pos="1170000"/>
                <a:tab algn="l" pos="2340000"/>
                <a:tab algn="l" pos="3510000"/>
                <a:tab algn="l" pos="4680000"/>
                <a:tab algn="l" pos="5850000"/>
                <a:tab algn="l" pos="7020000"/>
                <a:tab algn="l" pos="8190000"/>
                <a:tab algn="l" pos="9360000"/>
                <a:tab algn="l" pos="10530000"/>
              </a:tabLst>
            </a:pPr>
            <a:r>
              <a:rPr b="0" lang="en-US" sz="35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500" spc="-1" strike="noStrike">
              <a:solidFill>
                <a:srgbClr val="000000"/>
              </a:solidFill>
              <a:latin typeface="Calibri"/>
            </a:endParaRPr>
          </a:p>
          <a:p>
            <a:pPr lvl="2" marL="1461960" indent="-291960">
              <a:lnSpc>
                <a:spcPct val="90000"/>
              </a:lnSpc>
              <a:spcBef>
                <a:spcPts val="1276"/>
              </a:spcBef>
              <a:buClr>
                <a:srgbClr val="000000"/>
              </a:buClr>
              <a:buFont typeface="Arial"/>
              <a:buChar char="•"/>
              <a:tabLst>
                <a:tab algn="l" pos="1170000"/>
                <a:tab algn="l" pos="2340000"/>
                <a:tab algn="l" pos="3510000"/>
                <a:tab algn="l" pos="4680000"/>
                <a:tab algn="l" pos="5850000"/>
                <a:tab algn="l" pos="7020000"/>
                <a:tab algn="l" pos="8190000"/>
                <a:tab algn="l" pos="9360000"/>
                <a:tab algn="l" pos="10530000"/>
              </a:tabLst>
            </a:pPr>
            <a:r>
              <a:rPr b="0" lang="en-US" sz="35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500" spc="-1" strike="noStrike">
              <a:solidFill>
                <a:srgbClr val="000000"/>
              </a:solidFill>
              <a:latin typeface="Calibri"/>
            </a:endParaRPr>
          </a:p>
          <a:p>
            <a:pPr lvl="3" marL="2048040" indent="-292320">
              <a:lnSpc>
                <a:spcPct val="90000"/>
              </a:lnSpc>
              <a:spcBef>
                <a:spcPts val="1276"/>
              </a:spcBef>
              <a:buClr>
                <a:srgbClr val="000000"/>
              </a:buClr>
              <a:buFont typeface="Arial"/>
              <a:buChar char="•"/>
              <a:tabLst>
                <a:tab algn="l" pos="1170000"/>
                <a:tab algn="l" pos="2340000"/>
                <a:tab algn="l" pos="3510000"/>
                <a:tab algn="l" pos="4680000"/>
                <a:tab algn="l" pos="5850000"/>
                <a:tab algn="l" pos="7020000"/>
                <a:tab algn="l" pos="8190000"/>
                <a:tab algn="l" pos="9360000"/>
                <a:tab algn="l" pos="10530000"/>
              </a:tabLst>
            </a:pPr>
            <a:r>
              <a:rPr b="0" lang="en-US" sz="35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500" spc="-1" strike="noStrike">
              <a:solidFill>
                <a:srgbClr val="000000"/>
              </a:solidFill>
              <a:latin typeface="Calibri"/>
            </a:endParaRPr>
          </a:p>
          <a:p>
            <a:pPr lvl="4" marL="2633760" indent="-292320">
              <a:lnSpc>
                <a:spcPct val="90000"/>
              </a:lnSpc>
              <a:spcBef>
                <a:spcPts val="1276"/>
              </a:spcBef>
              <a:buClr>
                <a:srgbClr val="000000"/>
              </a:buClr>
              <a:buFont typeface="Arial"/>
              <a:buChar char="•"/>
              <a:tabLst>
                <a:tab algn="l" pos="1170000"/>
                <a:tab algn="l" pos="2340000"/>
                <a:tab algn="l" pos="3510000"/>
                <a:tab algn="l" pos="4680000"/>
                <a:tab algn="l" pos="5850000"/>
                <a:tab algn="l" pos="7020000"/>
                <a:tab algn="l" pos="8190000"/>
                <a:tab algn="l" pos="9360000"/>
                <a:tab algn="l" pos="10530000"/>
              </a:tabLst>
            </a:pPr>
            <a:r>
              <a:rPr b="0" lang="en-US" sz="35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500" spc="-1" strike="noStrike">
              <a:solidFill>
                <a:srgbClr val="000000"/>
              </a:solidFill>
              <a:latin typeface="Calibri"/>
            </a:endParaRPr>
          </a:p>
          <a:p>
            <a:pPr lvl="5" marL="2633760" indent="-292320">
              <a:lnSpc>
                <a:spcPct val="90000"/>
              </a:lnSpc>
              <a:spcBef>
                <a:spcPts val="1276"/>
              </a:spcBef>
              <a:buClr>
                <a:srgbClr val="000000"/>
              </a:buClr>
              <a:buFont typeface="Arial"/>
              <a:buChar char="•"/>
              <a:tabLst>
                <a:tab algn="l" pos="1170000"/>
                <a:tab algn="l" pos="2340000"/>
                <a:tab algn="l" pos="3510000"/>
                <a:tab algn="l" pos="4680000"/>
                <a:tab algn="l" pos="5850000"/>
                <a:tab algn="l" pos="7020000"/>
                <a:tab algn="l" pos="8190000"/>
                <a:tab algn="l" pos="9360000"/>
                <a:tab algn="l" pos="10530000"/>
              </a:tabLst>
            </a:pPr>
            <a:r>
              <a:rPr b="0" lang="en-US" sz="35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500" spc="-1" strike="noStrike">
              <a:solidFill>
                <a:srgbClr val="000000"/>
              </a:solidFill>
              <a:latin typeface="Calibri"/>
            </a:endParaRPr>
          </a:p>
          <a:p>
            <a:pPr lvl="6" marL="2633760" indent="-292320">
              <a:lnSpc>
                <a:spcPct val="90000"/>
              </a:lnSpc>
              <a:spcBef>
                <a:spcPts val="1276"/>
              </a:spcBef>
              <a:buClr>
                <a:srgbClr val="000000"/>
              </a:buClr>
              <a:buFont typeface="Arial"/>
              <a:buChar char="•"/>
              <a:tabLst>
                <a:tab algn="l" pos="1170000"/>
                <a:tab algn="l" pos="2340000"/>
                <a:tab algn="l" pos="3510000"/>
                <a:tab algn="l" pos="4680000"/>
                <a:tab algn="l" pos="5850000"/>
                <a:tab algn="l" pos="7020000"/>
                <a:tab algn="l" pos="8190000"/>
                <a:tab algn="l" pos="9360000"/>
                <a:tab algn="l" pos="10530000"/>
              </a:tabLst>
            </a:pPr>
            <a:r>
              <a:rPr b="0" lang="en-US" sz="35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1073160" y="8899560"/>
            <a:ext cx="3511440" cy="51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5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5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5170320" y="8899560"/>
            <a:ext cx="5266080" cy="51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11022120" y="8899560"/>
            <a:ext cx="3511440" cy="51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5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D5100434-E151-41EE-8939-531BA8801F33}" type="slidenum">
              <a:rPr b="0" lang="en-US" sz="15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wmf"/><Relationship Id="rId4" Type="http://schemas.openxmlformats.org/officeDocument/2006/relationships/image" Target="../media/image4.wmf"/><Relationship Id="rId5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5.jpeg"/><Relationship Id="rId2" Type="http://schemas.openxmlformats.org/officeDocument/2006/relationships/image" Target="../media/image6.jpeg"/><Relationship Id="rId3" Type="http://schemas.openxmlformats.org/officeDocument/2006/relationships/image" Target="../media/image7.png"/><Relationship Id="rId4" Type="http://schemas.openxmlformats.org/officeDocument/2006/relationships/image" Target="../media/image8.png"/><Relationship Id="rId5" Type="http://schemas.openxmlformats.org/officeDocument/2006/relationships/image" Target="../media/image9.png"/><Relationship Id="rId6" Type="http://schemas.openxmlformats.org/officeDocument/2006/relationships/image" Target="../media/image10.jpeg"/><Relationship Id="rId7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11"/>
          <p:cNvSpPr/>
          <p:nvPr/>
        </p:nvSpPr>
        <p:spPr>
          <a:xfrm>
            <a:off x="227880" y="541440"/>
            <a:ext cx="13666680" cy="1310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1: 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600" spc="-1" strike="noStrike">
                <a:solidFill>
                  <a:srgbClr val="000000"/>
                </a:solidFill>
                <a:latin typeface="Calibri"/>
              </a:rPr>
              <a:t>A) </a:t>
            </a:r>
            <a:r>
              <a:rPr b="0" lang="en-GB" sz="1600" spc="-1" strike="noStrike">
                <a:solidFill>
                  <a:srgbClr val="000000"/>
                </a:solidFill>
                <a:latin typeface="Calibri"/>
              </a:rPr>
              <a:t>Sanger sequencing of the ESR1 allele showing the presence of ESR1 mutation in BRx50. 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600" spc="-1" strike="noStrike">
                <a:solidFill>
                  <a:srgbClr val="000000"/>
                </a:solidFill>
                <a:latin typeface="Calibri"/>
              </a:rPr>
              <a:t>Nucleotide base change is indicated with a black arrow. 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600" spc="-1" strike="noStrike">
                <a:solidFill>
                  <a:srgbClr val="000000"/>
                </a:solidFill>
                <a:latin typeface="Calibri"/>
              </a:rPr>
              <a:t>B) </a:t>
            </a:r>
            <a:r>
              <a:rPr b="0" lang="en-GB" sz="1600" spc="-1" strike="noStrike">
                <a:solidFill>
                  <a:srgbClr val="000000"/>
                </a:solidFill>
                <a:latin typeface="Calibri"/>
              </a:rPr>
              <a:t>BRx140 and BRx50 CTC cell lines were treated with CDK4/6 inhibitors: ribociclib (500nM) and palbociclib (500nM) for 3 days and cell proliferation was evaluated. 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600" spc="-1" strike="noStrike">
                <a:solidFill>
                  <a:srgbClr val="000000"/>
                </a:solidFill>
                <a:latin typeface="Calibri"/>
              </a:rPr>
              <a:t>Both CTC lines are resistant to treatment CDK4/6 inhibitors. 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TextBox 15"/>
          <p:cNvSpPr/>
          <p:nvPr/>
        </p:nvSpPr>
        <p:spPr>
          <a:xfrm>
            <a:off x="4503600" y="3591000"/>
            <a:ext cx="2090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BRx50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(ESR1 MUT L536P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3" name="Picture 16" descr=""/>
          <p:cNvPicPr/>
          <p:nvPr/>
        </p:nvPicPr>
        <p:blipFill>
          <a:blip r:embed="rId1"/>
          <a:srcRect l="38536" t="6051" r="23966" b="9772"/>
          <a:stretch/>
        </p:blipFill>
        <p:spPr>
          <a:xfrm>
            <a:off x="4476600" y="3870360"/>
            <a:ext cx="2000520" cy="226548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pic>
        <p:nvPicPr>
          <p:cNvPr id="44" name="Picture 17" descr=""/>
          <p:cNvPicPr/>
          <p:nvPr/>
        </p:nvPicPr>
        <p:blipFill>
          <a:blip r:embed="rId2"/>
          <a:srcRect l="28264" t="5743" r="32978" b="10080"/>
          <a:stretch/>
        </p:blipFill>
        <p:spPr>
          <a:xfrm>
            <a:off x="2359080" y="3871800"/>
            <a:ext cx="2000160" cy="226404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sp>
        <p:nvSpPr>
          <p:cNvPr id="45" name="Rectangle 18"/>
          <p:cNvSpPr/>
          <p:nvPr/>
        </p:nvSpPr>
        <p:spPr>
          <a:xfrm>
            <a:off x="2993760" y="4498920"/>
            <a:ext cx="743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  T  C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Rectangle 19"/>
          <p:cNvSpPr/>
          <p:nvPr/>
        </p:nvSpPr>
        <p:spPr>
          <a:xfrm>
            <a:off x="5077440" y="4421160"/>
            <a:ext cx="735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      C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47" name="Straight Arrow Connector 7"/>
          <p:cNvCxnSpPr/>
          <p:nvPr/>
        </p:nvCxnSpPr>
        <p:spPr>
          <a:xfrm>
            <a:off x="5473440" y="5322960"/>
            <a:ext cx="1080" cy="24048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48" name="Rectangle 21"/>
          <p:cNvSpPr/>
          <p:nvPr/>
        </p:nvSpPr>
        <p:spPr>
          <a:xfrm>
            <a:off x="5346000" y="5843520"/>
            <a:ext cx="26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TextBox 15"/>
          <p:cNvSpPr/>
          <p:nvPr/>
        </p:nvSpPr>
        <p:spPr>
          <a:xfrm>
            <a:off x="2373480" y="3589200"/>
            <a:ext cx="2000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BRx140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(ESR1 WT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TextBox 16"/>
          <p:cNvSpPr/>
          <p:nvPr/>
        </p:nvSpPr>
        <p:spPr>
          <a:xfrm>
            <a:off x="6976080" y="269712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TextBox 11"/>
          <p:cNvSpPr/>
          <p:nvPr/>
        </p:nvSpPr>
        <p:spPr>
          <a:xfrm>
            <a:off x="1769040" y="269712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Rectangle 1"/>
          <p:cNvSpPr/>
          <p:nvPr/>
        </p:nvSpPr>
        <p:spPr>
          <a:xfrm>
            <a:off x="5298480" y="4691160"/>
            <a:ext cx="302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Calibri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Rectangle 36"/>
          <p:cNvSpPr/>
          <p:nvPr/>
        </p:nvSpPr>
        <p:spPr>
          <a:xfrm>
            <a:off x="5313240" y="4148280"/>
            <a:ext cx="291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Calibri"/>
              </a:rPr>
              <a:t>T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54" name="Group 4"/>
          <p:cNvGrpSpPr/>
          <p:nvPr/>
        </p:nvGrpSpPr>
        <p:grpSpPr>
          <a:xfrm>
            <a:off x="7615080" y="3405240"/>
            <a:ext cx="4735800" cy="3287160"/>
            <a:chOff x="7615080" y="3405240"/>
            <a:chExt cx="4735800" cy="3287160"/>
          </a:xfrm>
        </p:grpSpPr>
        <p:grpSp>
          <p:nvGrpSpPr>
            <p:cNvPr id="55" name="Group 8"/>
            <p:cNvGrpSpPr/>
            <p:nvPr/>
          </p:nvGrpSpPr>
          <p:grpSpPr>
            <a:xfrm>
              <a:off x="7615080" y="3405240"/>
              <a:ext cx="4735800" cy="3287160"/>
              <a:chOff x="7615080" y="3405240"/>
              <a:chExt cx="4735800" cy="3287160"/>
            </a:xfrm>
          </p:grpSpPr>
          <p:sp>
            <p:nvSpPr>
              <p:cNvPr id="56" name="TextBox 55"/>
              <p:cNvSpPr/>
              <p:nvPr/>
            </p:nvSpPr>
            <p:spPr>
              <a:xfrm>
                <a:off x="10461600" y="5850720"/>
                <a:ext cx="3942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.0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7" name="TextBox 56"/>
              <p:cNvSpPr/>
              <p:nvPr/>
            </p:nvSpPr>
            <p:spPr>
              <a:xfrm>
                <a:off x="10461600" y="5133240"/>
                <a:ext cx="3942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.5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8" name="TextBox 57"/>
              <p:cNvSpPr/>
              <p:nvPr/>
            </p:nvSpPr>
            <p:spPr>
              <a:xfrm>
                <a:off x="10451520" y="4425480"/>
                <a:ext cx="3942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.0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9" name="TextBox 58"/>
              <p:cNvSpPr/>
              <p:nvPr/>
            </p:nvSpPr>
            <p:spPr>
              <a:xfrm>
                <a:off x="10461600" y="3708720"/>
                <a:ext cx="3942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.5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0" name="TextBox 64"/>
              <p:cNvSpPr/>
              <p:nvPr/>
            </p:nvSpPr>
            <p:spPr>
              <a:xfrm rot="19344600">
                <a:off x="10631880" y="6082200"/>
                <a:ext cx="6379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DMSO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1" name="TextBox 68"/>
              <p:cNvSpPr/>
              <p:nvPr/>
            </p:nvSpPr>
            <p:spPr>
              <a:xfrm rot="16200000">
                <a:off x="9640080" y="4817880"/>
                <a:ext cx="16056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Relative Cell Viability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2" name="TextBox 51"/>
              <p:cNvSpPr/>
              <p:nvPr/>
            </p:nvSpPr>
            <p:spPr>
              <a:xfrm>
                <a:off x="7779240" y="5857920"/>
                <a:ext cx="3942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.0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3" name="TextBox 52"/>
              <p:cNvSpPr/>
              <p:nvPr/>
            </p:nvSpPr>
            <p:spPr>
              <a:xfrm>
                <a:off x="7779240" y="5149800"/>
                <a:ext cx="3942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.5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4" name="TextBox 53"/>
              <p:cNvSpPr/>
              <p:nvPr/>
            </p:nvSpPr>
            <p:spPr>
              <a:xfrm>
                <a:off x="7779240" y="4435200"/>
                <a:ext cx="3942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.0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5" name="TextBox 54"/>
              <p:cNvSpPr/>
              <p:nvPr/>
            </p:nvSpPr>
            <p:spPr>
              <a:xfrm>
                <a:off x="7769160" y="3719160"/>
                <a:ext cx="3942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.5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6" name="TextBox 60"/>
              <p:cNvSpPr/>
              <p:nvPr/>
            </p:nvSpPr>
            <p:spPr>
              <a:xfrm rot="19344600">
                <a:off x="7955280" y="6096600"/>
                <a:ext cx="6379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DMSO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7" name="TextBox 70"/>
              <p:cNvSpPr/>
              <p:nvPr/>
            </p:nvSpPr>
            <p:spPr>
              <a:xfrm rot="16200000">
                <a:off x="6950520" y="4817880"/>
                <a:ext cx="16056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Relative Cell Viability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8" name="TextBox 12"/>
              <p:cNvSpPr/>
              <p:nvPr/>
            </p:nvSpPr>
            <p:spPr>
              <a:xfrm>
                <a:off x="8202240" y="3405240"/>
                <a:ext cx="16686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BRx140</a:t>
                </a: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 (HER2 MUT)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9" name="TextBox 14"/>
              <p:cNvSpPr/>
              <p:nvPr/>
            </p:nvSpPr>
            <p:spPr>
              <a:xfrm>
                <a:off x="10847520" y="3405240"/>
                <a:ext cx="15033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BRx50 </a:t>
                </a: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(HER2 WT)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0" name="TextBox 62"/>
              <p:cNvSpPr/>
              <p:nvPr/>
            </p:nvSpPr>
            <p:spPr>
              <a:xfrm rot="19344600">
                <a:off x="8227080" y="6145920"/>
                <a:ext cx="8330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Ribociclib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1" name="TextBox 62"/>
              <p:cNvSpPr/>
              <p:nvPr/>
            </p:nvSpPr>
            <p:spPr>
              <a:xfrm rot="19344600">
                <a:off x="10907280" y="6120720"/>
                <a:ext cx="8330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Ribociclib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2" name="TextBox 62"/>
              <p:cNvSpPr/>
              <p:nvPr/>
            </p:nvSpPr>
            <p:spPr>
              <a:xfrm rot="19344600">
                <a:off x="8593200" y="6166440"/>
                <a:ext cx="9108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Palbociclib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3" name="TextBox 62"/>
              <p:cNvSpPr/>
              <p:nvPr/>
            </p:nvSpPr>
            <p:spPr>
              <a:xfrm rot="19344600">
                <a:off x="11253600" y="6139440"/>
                <a:ext cx="9108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Palbociclib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pic>
          <p:nvPicPr>
            <p:cNvPr id="74" name="Picture 1" descr=""/>
            <p:cNvPicPr/>
            <p:nvPr/>
          </p:nvPicPr>
          <p:blipFill>
            <a:blip r:embed="rId3"/>
            <a:srcRect l="11676" t="6006" r="59619" b="26035"/>
            <a:stretch/>
          </p:blipFill>
          <p:spPr>
            <a:xfrm>
              <a:off x="8079120" y="3730320"/>
              <a:ext cx="1591560" cy="23864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5" name="Picture 2" descr=""/>
            <p:cNvPicPr/>
            <p:nvPr/>
          </p:nvPicPr>
          <p:blipFill>
            <a:blip r:embed="rId4"/>
            <a:srcRect l="17440" t="0" r="40409" b="26278"/>
            <a:stretch/>
          </p:blipFill>
          <p:spPr>
            <a:xfrm>
              <a:off x="10751760" y="3511440"/>
              <a:ext cx="1538280" cy="2566800"/>
            </a:xfrm>
            <a:prstGeom prst="rect">
              <a:avLst/>
            </a:prstGeom>
            <a:ln w="0">
              <a:noFill/>
            </a:ln>
          </p:spPr>
        </p:pic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6" name="TextBox 58"/>
          <p:cNvSpPr/>
          <p:nvPr/>
        </p:nvSpPr>
        <p:spPr>
          <a:xfrm>
            <a:off x="8677440" y="1905120"/>
            <a:ext cx="114444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Arial"/>
                <a:ea typeface="Arial"/>
              </a:rPr>
              <a:t>185kDa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77" name="Group 8"/>
          <p:cNvGrpSpPr/>
          <p:nvPr/>
        </p:nvGrpSpPr>
        <p:grpSpPr>
          <a:xfrm>
            <a:off x="5170320" y="379440"/>
            <a:ext cx="4168800" cy="1973160"/>
            <a:chOff x="5170320" y="379440"/>
            <a:chExt cx="4168800" cy="1973160"/>
          </a:xfrm>
        </p:grpSpPr>
        <p:sp>
          <p:nvSpPr>
            <p:cNvPr id="78" name="TextBox 37"/>
            <p:cNvSpPr/>
            <p:nvPr/>
          </p:nvSpPr>
          <p:spPr>
            <a:xfrm>
              <a:off x="5549760" y="1011240"/>
              <a:ext cx="90000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  <a:ea typeface="Arial"/>
                </a:rPr>
                <a:t>Neratinib</a:t>
              </a:r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9" name="TextBox 38"/>
            <p:cNvSpPr/>
            <p:nvPr/>
          </p:nvSpPr>
          <p:spPr>
            <a:xfrm>
              <a:off x="6576840" y="1011240"/>
              <a:ext cx="39204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  <a:ea typeface="Arial"/>
                </a:rPr>
                <a:t>-</a:t>
              </a:r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0" name="TextBox 39"/>
            <p:cNvSpPr/>
            <p:nvPr/>
          </p:nvSpPr>
          <p:spPr>
            <a:xfrm>
              <a:off x="7153200" y="1011240"/>
              <a:ext cx="38880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1" name="TextBox 40"/>
            <p:cNvSpPr/>
            <p:nvPr/>
          </p:nvSpPr>
          <p:spPr>
            <a:xfrm>
              <a:off x="7662600" y="1011240"/>
              <a:ext cx="39024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  <a:ea typeface="Arial"/>
                </a:rPr>
                <a:t>-</a:t>
              </a:r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2" name="TextBox 41"/>
            <p:cNvSpPr/>
            <p:nvPr/>
          </p:nvSpPr>
          <p:spPr>
            <a:xfrm>
              <a:off x="8142120" y="1011240"/>
              <a:ext cx="38880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3" name="TextBox 42"/>
            <p:cNvSpPr/>
            <p:nvPr/>
          </p:nvSpPr>
          <p:spPr>
            <a:xfrm>
              <a:off x="6431400" y="379440"/>
              <a:ext cx="1022040" cy="489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300" spc="-1" strike="noStrike">
                  <a:solidFill>
                    <a:srgbClr val="000000"/>
                  </a:solidFill>
                  <a:latin typeface="Arial"/>
                  <a:ea typeface="Arial"/>
                </a:rPr>
                <a:t>BRx140</a:t>
              </a:r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300" spc="-1" strike="noStrike">
                  <a:solidFill>
                    <a:srgbClr val="000000"/>
                  </a:solidFill>
                  <a:latin typeface="Arial"/>
                  <a:ea typeface="Arial"/>
                </a:rPr>
                <a:t>HER2 MUT</a:t>
              </a:r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4" name="TextBox 44"/>
            <p:cNvSpPr/>
            <p:nvPr/>
          </p:nvSpPr>
          <p:spPr>
            <a:xfrm>
              <a:off x="7502400" y="379440"/>
              <a:ext cx="990360" cy="489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300" spc="-1" strike="noStrike">
                  <a:solidFill>
                    <a:srgbClr val="000000"/>
                  </a:solidFill>
                  <a:latin typeface="Arial"/>
                  <a:ea typeface="Arial"/>
                </a:rPr>
                <a:t>BRx50</a:t>
              </a:r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300" spc="-1" strike="noStrike">
                  <a:solidFill>
                    <a:srgbClr val="000000"/>
                  </a:solidFill>
                  <a:latin typeface="Arial"/>
                  <a:ea typeface="Arial"/>
                </a:rPr>
                <a:t>HER2 WT</a:t>
              </a:r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5" name="Rectangle 16"/>
            <p:cNvSpPr/>
            <p:nvPr/>
          </p:nvSpPr>
          <p:spPr>
            <a:xfrm flipV="1">
              <a:off x="6451200" y="832680"/>
              <a:ext cx="1009440" cy="5364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6" name="Rectangle 17"/>
            <p:cNvSpPr/>
            <p:nvPr/>
          </p:nvSpPr>
          <p:spPr>
            <a:xfrm flipV="1">
              <a:off x="7519680" y="832680"/>
              <a:ext cx="1011240" cy="5364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7" name="TextBox 58"/>
            <p:cNvSpPr/>
            <p:nvPr/>
          </p:nvSpPr>
          <p:spPr>
            <a:xfrm>
              <a:off x="8194680" y="1596960"/>
              <a:ext cx="114444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  <a:ea typeface="Arial"/>
                </a:rPr>
                <a:t>HER2</a:t>
              </a:r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8" name="TextBox 58"/>
            <p:cNvSpPr/>
            <p:nvPr/>
          </p:nvSpPr>
          <p:spPr>
            <a:xfrm>
              <a:off x="5173200" y="1905120"/>
              <a:ext cx="114444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  <a:ea typeface="Arial"/>
                </a:rPr>
                <a:t>150kDa</a:t>
              </a:r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89" name="Picture 57" descr=""/>
            <p:cNvPicPr/>
            <p:nvPr/>
          </p:nvPicPr>
          <p:blipFill>
            <a:blip r:embed="rId1"/>
            <a:srcRect l="5419" t="92544" r="77268" b="4313"/>
            <a:stretch/>
          </p:blipFill>
          <p:spPr>
            <a:xfrm>
              <a:off x="5991480" y="1426320"/>
              <a:ext cx="2643120" cy="926280"/>
            </a:xfrm>
            <a:prstGeom prst="rect">
              <a:avLst/>
            </a:prstGeom>
            <a:ln w="12600">
              <a:solidFill>
                <a:srgbClr val="000000"/>
              </a:solidFill>
              <a:miter/>
            </a:ln>
          </p:spPr>
        </p:pic>
        <p:sp>
          <p:nvSpPr>
            <p:cNvPr id="90" name="TextBox 58"/>
            <p:cNvSpPr/>
            <p:nvPr/>
          </p:nvSpPr>
          <p:spPr>
            <a:xfrm>
              <a:off x="5170320" y="1386000"/>
              <a:ext cx="114444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  <a:ea typeface="Arial"/>
                </a:rPr>
                <a:t>250kDa</a:t>
              </a:r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cxnSp>
          <p:nvCxnSpPr>
            <p:cNvPr id="91" name="Straight Arrow Connector 22"/>
            <p:cNvCxnSpPr/>
            <p:nvPr/>
          </p:nvCxnSpPr>
          <p:spPr>
            <a:xfrm>
              <a:off x="5284080" y="1892160"/>
              <a:ext cx="1166040" cy="13320"/>
            </a:xfrm>
            <a:prstGeom prst="straightConnector1">
              <a:avLst/>
            </a:prstGeom>
            <a:ln w="41400">
              <a:solidFill>
                <a:srgbClr val="ff0000"/>
              </a:solidFill>
              <a:miter/>
              <a:tailEnd len="med" type="triangle" w="med"/>
            </a:ln>
          </p:spPr>
        </p:cxnSp>
      </p:grpSp>
      <p:grpSp>
        <p:nvGrpSpPr>
          <p:cNvPr id="92" name="Group 23"/>
          <p:cNvGrpSpPr/>
          <p:nvPr/>
        </p:nvGrpSpPr>
        <p:grpSpPr>
          <a:xfrm>
            <a:off x="5057280" y="3003480"/>
            <a:ext cx="4723200" cy="2801880"/>
            <a:chOff x="5057280" y="3003480"/>
            <a:chExt cx="4723200" cy="2801880"/>
          </a:xfrm>
        </p:grpSpPr>
        <p:pic>
          <p:nvPicPr>
            <p:cNvPr id="93" name="Picture 63" descr=""/>
            <p:cNvPicPr/>
            <p:nvPr/>
          </p:nvPicPr>
          <p:blipFill>
            <a:blip r:embed="rId2"/>
            <a:srcRect l="3592" t="19305" r="78585" b="71206"/>
            <a:stretch/>
          </p:blipFill>
          <p:spPr>
            <a:xfrm>
              <a:off x="5926680" y="3927600"/>
              <a:ext cx="2629440" cy="1877760"/>
            </a:xfrm>
            <a:prstGeom prst="rect">
              <a:avLst/>
            </a:prstGeom>
            <a:ln w="12600">
              <a:solidFill>
                <a:srgbClr val="000000"/>
              </a:solidFill>
              <a:miter/>
            </a:ln>
          </p:spPr>
        </p:pic>
        <p:sp>
          <p:nvSpPr>
            <p:cNvPr id="94" name="TextBox 37"/>
            <p:cNvSpPr/>
            <p:nvPr/>
          </p:nvSpPr>
          <p:spPr>
            <a:xfrm>
              <a:off x="5551200" y="3633480"/>
              <a:ext cx="90000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  <a:ea typeface="Arial"/>
                </a:rPr>
                <a:t>Neratinib</a:t>
              </a:r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5" name="TextBox 38"/>
            <p:cNvSpPr/>
            <p:nvPr/>
          </p:nvSpPr>
          <p:spPr>
            <a:xfrm>
              <a:off x="6653160" y="3601800"/>
              <a:ext cx="39204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  <a:ea typeface="Arial"/>
                </a:rPr>
                <a:t>-</a:t>
              </a:r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6" name="TextBox 39"/>
            <p:cNvSpPr/>
            <p:nvPr/>
          </p:nvSpPr>
          <p:spPr>
            <a:xfrm>
              <a:off x="7119720" y="3633480"/>
              <a:ext cx="39024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7" name="TextBox 40"/>
            <p:cNvSpPr/>
            <p:nvPr/>
          </p:nvSpPr>
          <p:spPr>
            <a:xfrm>
              <a:off x="7576920" y="3633480"/>
              <a:ext cx="39204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  <a:ea typeface="Arial"/>
                </a:rPr>
                <a:t>-</a:t>
              </a:r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8" name="TextBox 41"/>
            <p:cNvSpPr/>
            <p:nvPr/>
          </p:nvSpPr>
          <p:spPr>
            <a:xfrm>
              <a:off x="8143920" y="3633480"/>
              <a:ext cx="39024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9" name="TextBox 42"/>
            <p:cNvSpPr/>
            <p:nvPr/>
          </p:nvSpPr>
          <p:spPr>
            <a:xfrm>
              <a:off x="6433200" y="3003480"/>
              <a:ext cx="1022040" cy="489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300" spc="-1" strike="noStrike">
                  <a:solidFill>
                    <a:srgbClr val="000000"/>
                  </a:solidFill>
                  <a:latin typeface="Arial"/>
                  <a:ea typeface="Arial"/>
                </a:rPr>
                <a:t>BRx140</a:t>
              </a:r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300" spc="-1" strike="noStrike">
                  <a:solidFill>
                    <a:srgbClr val="000000"/>
                  </a:solidFill>
                  <a:latin typeface="Arial"/>
                  <a:ea typeface="Arial"/>
                </a:rPr>
                <a:t>HER2 MUT</a:t>
              </a:r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0" name="TextBox 44"/>
            <p:cNvSpPr/>
            <p:nvPr/>
          </p:nvSpPr>
          <p:spPr>
            <a:xfrm>
              <a:off x="7503840" y="3003480"/>
              <a:ext cx="990360" cy="489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300" spc="-1" strike="noStrike">
                  <a:solidFill>
                    <a:srgbClr val="000000"/>
                  </a:solidFill>
                  <a:latin typeface="Arial"/>
                  <a:ea typeface="Arial"/>
                </a:rPr>
                <a:t>BRx50</a:t>
              </a:r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300" spc="-1" strike="noStrike">
                  <a:solidFill>
                    <a:srgbClr val="000000"/>
                  </a:solidFill>
                  <a:latin typeface="Arial"/>
                  <a:ea typeface="Arial"/>
                </a:rPr>
                <a:t>HER2 WT</a:t>
              </a:r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1" name="Rectangle 32"/>
            <p:cNvSpPr/>
            <p:nvPr/>
          </p:nvSpPr>
          <p:spPr>
            <a:xfrm flipV="1">
              <a:off x="6453000" y="3455640"/>
              <a:ext cx="1009440" cy="5544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8640" bIns="864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2" name="Rectangle 33"/>
            <p:cNvSpPr/>
            <p:nvPr/>
          </p:nvSpPr>
          <p:spPr>
            <a:xfrm flipV="1">
              <a:off x="7522920" y="3455640"/>
              <a:ext cx="1011240" cy="5544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8640" bIns="864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3" name="TextBox 58"/>
            <p:cNvSpPr/>
            <p:nvPr/>
          </p:nvSpPr>
          <p:spPr>
            <a:xfrm>
              <a:off x="8636040" y="4329000"/>
              <a:ext cx="114444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  <a:ea typeface="Arial"/>
                </a:rPr>
                <a:t>32kDa</a:t>
              </a:r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4" name="TextBox 62"/>
            <p:cNvSpPr/>
            <p:nvPr/>
          </p:nvSpPr>
          <p:spPr>
            <a:xfrm>
              <a:off x="8616960" y="4020840"/>
              <a:ext cx="116352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  <a:ea typeface="Arial"/>
                </a:rPr>
                <a:t>Phospho-S6</a:t>
              </a:r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5" name="TextBox 58"/>
            <p:cNvSpPr/>
            <p:nvPr/>
          </p:nvSpPr>
          <p:spPr>
            <a:xfrm>
              <a:off x="5078160" y="5419800"/>
              <a:ext cx="114444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kDa</a:t>
              </a:r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6" name="TextBox 58"/>
            <p:cNvSpPr/>
            <p:nvPr/>
          </p:nvSpPr>
          <p:spPr>
            <a:xfrm>
              <a:off x="5078160" y="5062680"/>
              <a:ext cx="114444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  <a:ea typeface="Arial"/>
                </a:rPr>
                <a:t>15kDa</a:t>
              </a:r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7" name="TextBox 58"/>
            <p:cNvSpPr/>
            <p:nvPr/>
          </p:nvSpPr>
          <p:spPr>
            <a:xfrm>
              <a:off x="5078160" y="4633920"/>
              <a:ext cx="114444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  <a:ea typeface="Arial"/>
                </a:rPr>
                <a:t>20kDa</a:t>
              </a:r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8" name="TextBox 58"/>
            <p:cNvSpPr/>
            <p:nvPr/>
          </p:nvSpPr>
          <p:spPr>
            <a:xfrm>
              <a:off x="5078160" y="4340160"/>
              <a:ext cx="114444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  <a:ea typeface="Arial"/>
                </a:rPr>
                <a:t>25kDa</a:t>
              </a:r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9" name="TextBox 58"/>
            <p:cNvSpPr/>
            <p:nvPr/>
          </p:nvSpPr>
          <p:spPr>
            <a:xfrm>
              <a:off x="5078160" y="3843000"/>
              <a:ext cx="114444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  <a:ea typeface="Arial"/>
                </a:rPr>
                <a:t>37kDa</a:t>
              </a:r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cxnSp>
          <p:nvCxnSpPr>
            <p:cNvPr id="110" name="Straight Arrow Connector 41"/>
            <p:cNvCxnSpPr/>
            <p:nvPr/>
          </p:nvCxnSpPr>
          <p:spPr>
            <a:xfrm>
              <a:off x="5057280" y="4279680"/>
              <a:ext cx="1166040" cy="11520"/>
            </a:xfrm>
            <a:prstGeom prst="straightConnector1">
              <a:avLst/>
            </a:prstGeom>
            <a:ln w="41400">
              <a:solidFill>
                <a:srgbClr val="ff0000"/>
              </a:solidFill>
              <a:miter/>
              <a:tailEnd len="med" type="triangle" w="med"/>
            </a:ln>
          </p:spPr>
        </p:cxnSp>
      </p:grpSp>
      <p:grpSp>
        <p:nvGrpSpPr>
          <p:cNvPr id="111" name="Group 42"/>
          <p:cNvGrpSpPr/>
          <p:nvPr/>
        </p:nvGrpSpPr>
        <p:grpSpPr>
          <a:xfrm>
            <a:off x="10010880" y="285840"/>
            <a:ext cx="4841640" cy="2319120"/>
            <a:chOff x="10010880" y="285840"/>
            <a:chExt cx="4841640" cy="2319120"/>
          </a:xfrm>
        </p:grpSpPr>
        <p:pic>
          <p:nvPicPr>
            <p:cNvPr id="112" name="Picture 56" descr=""/>
            <p:cNvPicPr/>
            <p:nvPr/>
          </p:nvPicPr>
          <p:blipFill>
            <a:blip r:embed="rId3"/>
            <a:srcRect l="10577" t="24855" r="54724" b="49547"/>
            <a:stretch/>
          </p:blipFill>
          <p:spPr>
            <a:xfrm>
              <a:off x="10854720" y="1206360"/>
              <a:ext cx="2764080" cy="1398600"/>
            </a:xfrm>
            <a:prstGeom prst="rect">
              <a:avLst/>
            </a:prstGeom>
            <a:ln w="12600">
              <a:solidFill>
                <a:srgbClr val="000000"/>
              </a:solidFill>
              <a:miter/>
            </a:ln>
          </p:spPr>
        </p:pic>
        <p:sp>
          <p:nvSpPr>
            <p:cNvPr id="113" name="TextBox 37"/>
            <p:cNvSpPr/>
            <p:nvPr/>
          </p:nvSpPr>
          <p:spPr>
            <a:xfrm>
              <a:off x="10517040" y="915840"/>
              <a:ext cx="90144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  <a:ea typeface="Arial"/>
                </a:rPr>
                <a:t>Neratinib</a:t>
              </a:r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4" name="TextBox 38"/>
            <p:cNvSpPr/>
            <p:nvPr/>
          </p:nvSpPr>
          <p:spPr>
            <a:xfrm>
              <a:off x="11534760" y="915840"/>
              <a:ext cx="39204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  <a:ea typeface="Arial"/>
                </a:rPr>
                <a:t>-</a:t>
              </a:r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5" name="TextBox 39"/>
            <p:cNvSpPr/>
            <p:nvPr/>
          </p:nvSpPr>
          <p:spPr>
            <a:xfrm>
              <a:off x="12023640" y="915840"/>
              <a:ext cx="39024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6" name="TextBox 40"/>
            <p:cNvSpPr/>
            <p:nvPr/>
          </p:nvSpPr>
          <p:spPr>
            <a:xfrm>
              <a:off x="12544560" y="915840"/>
              <a:ext cx="39204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  <a:ea typeface="Arial"/>
                </a:rPr>
                <a:t>-</a:t>
              </a:r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7" name="TextBox 41"/>
            <p:cNvSpPr/>
            <p:nvPr/>
          </p:nvSpPr>
          <p:spPr>
            <a:xfrm>
              <a:off x="13111200" y="915840"/>
              <a:ext cx="39024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8" name="TextBox 42"/>
            <p:cNvSpPr/>
            <p:nvPr/>
          </p:nvSpPr>
          <p:spPr>
            <a:xfrm>
              <a:off x="11400480" y="285840"/>
              <a:ext cx="1022040" cy="489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300" spc="-1" strike="noStrike">
                  <a:solidFill>
                    <a:srgbClr val="000000"/>
                  </a:solidFill>
                  <a:latin typeface="Arial"/>
                  <a:ea typeface="Arial"/>
                </a:rPr>
                <a:t>BRx140</a:t>
              </a:r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300" spc="-1" strike="noStrike">
                  <a:solidFill>
                    <a:srgbClr val="000000"/>
                  </a:solidFill>
                  <a:latin typeface="Arial"/>
                  <a:ea typeface="Arial"/>
                </a:rPr>
                <a:t>HER2 MUT</a:t>
              </a:r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9" name="TextBox 44"/>
            <p:cNvSpPr/>
            <p:nvPr/>
          </p:nvSpPr>
          <p:spPr>
            <a:xfrm>
              <a:off x="12471480" y="285840"/>
              <a:ext cx="990360" cy="489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300" spc="-1" strike="noStrike">
                  <a:solidFill>
                    <a:srgbClr val="000000"/>
                  </a:solidFill>
                  <a:latin typeface="Arial"/>
                  <a:ea typeface="Arial"/>
                </a:rPr>
                <a:t>BRx50</a:t>
              </a:r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300" spc="-1" strike="noStrike">
                  <a:solidFill>
                    <a:srgbClr val="000000"/>
                  </a:solidFill>
                  <a:latin typeface="Arial"/>
                  <a:ea typeface="Arial"/>
                </a:rPr>
                <a:t>HER2 WT</a:t>
              </a:r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0" name="Rectangle 51"/>
            <p:cNvSpPr/>
            <p:nvPr/>
          </p:nvSpPr>
          <p:spPr>
            <a:xfrm flipV="1">
              <a:off x="11420280" y="738000"/>
              <a:ext cx="1009440" cy="5544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8640" bIns="864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1" name="Rectangle 52"/>
            <p:cNvSpPr/>
            <p:nvPr/>
          </p:nvSpPr>
          <p:spPr>
            <a:xfrm flipV="1">
              <a:off x="12488760" y="738000"/>
              <a:ext cx="1012680" cy="5544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8640" bIns="864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2" name="TextBox 58"/>
            <p:cNvSpPr/>
            <p:nvPr/>
          </p:nvSpPr>
          <p:spPr>
            <a:xfrm>
              <a:off x="13708080" y="1828800"/>
              <a:ext cx="114444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  <a:ea typeface="Arial"/>
                </a:rPr>
                <a:t>32kDa</a:t>
              </a:r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3" name="TextBox 62"/>
            <p:cNvSpPr/>
            <p:nvPr/>
          </p:nvSpPr>
          <p:spPr>
            <a:xfrm>
              <a:off x="13304880" y="1571760"/>
              <a:ext cx="116496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  <a:ea typeface="Arial"/>
                </a:rPr>
                <a:t>Total-S6</a:t>
              </a:r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4" name="TextBox 58"/>
            <p:cNvSpPr/>
            <p:nvPr/>
          </p:nvSpPr>
          <p:spPr>
            <a:xfrm>
              <a:off x="10161360" y="2081160"/>
              <a:ext cx="114588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  <a:ea typeface="Arial"/>
                </a:rPr>
                <a:t>37kDa</a:t>
              </a:r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5" name="TextBox 58"/>
            <p:cNvSpPr/>
            <p:nvPr/>
          </p:nvSpPr>
          <p:spPr>
            <a:xfrm>
              <a:off x="10148760" y="1692360"/>
              <a:ext cx="114444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  <a:ea typeface="Arial"/>
                </a:rPr>
                <a:t>50kDa</a:t>
              </a:r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6" name="TextBox 58"/>
            <p:cNvSpPr/>
            <p:nvPr/>
          </p:nvSpPr>
          <p:spPr>
            <a:xfrm>
              <a:off x="10161360" y="1147680"/>
              <a:ext cx="114588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  <a:ea typeface="Arial"/>
                </a:rPr>
                <a:t>75kDa</a:t>
              </a:r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cxnSp>
          <p:nvCxnSpPr>
            <p:cNvPr id="127" name="Straight Arrow Connector 58"/>
            <p:cNvCxnSpPr/>
            <p:nvPr/>
          </p:nvCxnSpPr>
          <p:spPr>
            <a:xfrm>
              <a:off x="10010880" y="2493720"/>
              <a:ext cx="1165680" cy="13320"/>
            </a:xfrm>
            <a:prstGeom prst="straightConnector1">
              <a:avLst/>
            </a:prstGeom>
            <a:ln w="41400">
              <a:solidFill>
                <a:srgbClr val="ff0000"/>
              </a:solidFill>
              <a:miter/>
              <a:tailEnd len="med" type="triangle" w="med"/>
            </a:ln>
          </p:spPr>
        </p:cxnSp>
      </p:grpSp>
      <p:pic>
        <p:nvPicPr>
          <p:cNvPr id="128" name="Picture 2" descr=""/>
          <p:cNvPicPr/>
          <p:nvPr/>
        </p:nvPicPr>
        <p:blipFill>
          <a:blip r:embed="rId4"/>
          <a:srcRect l="7406" t="15520" r="44796" b="67411"/>
          <a:stretch/>
        </p:blipFill>
        <p:spPr>
          <a:xfrm>
            <a:off x="10677600" y="4562640"/>
            <a:ext cx="2851200" cy="100296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sp>
        <p:nvSpPr>
          <p:cNvPr id="129" name="TextBox 37"/>
          <p:cNvSpPr/>
          <p:nvPr/>
        </p:nvSpPr>
        <p:spPr>
          <a:xfrm>
            <a:off x="10420200" y="4286160"/>
            <a:ext cx="90180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Arial"/>
                <a:ea typeface="Arial"/>
              </a:rPr>
              <a:t>Neratinib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0" name="TextBox 38"/>
          <p:cNvSpPr/>
          <p:nvPr/>
        </p:nvSpPr>
        <p:spPr>
          <a:xfrm>
            <a:off x="11469600" y="4286160"/>
            <a:ext cx="39384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Arial"/>
                <a:ea typeface="Arial"/>
              </a:rPr>
              <a:t>-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1" name="TextBox 39"/>
          <p:cNvSpPr/>
          <p:nvPr/>
        </p:nvSpPr>
        <p:spPr>
          <a:xfrm>
            <a:off x="11969640" y="4286160"/>
            <a:ext cx="39060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Arial"/>
                <a:ea typeface="Arial"/>
              </a:rPr>
              <a:t>+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2" name="TextBox 40"/>
          <p:cNvSpPr/>
          <p:nvPr/>
        </p:nvSpPr>
        <p:spPr>
          <a:xfrm>
            <a:off x="12522240" y="4286160"/>
            <a:ext cx="39204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Arial"/>
                <a:ea typeface="Arial"/>
              </a:rPr>
              <a:t>-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3" name="TextBox 41"/>
          <p:cNvSpPr/>
          <p:nvPr/>
        </p:nvSpPr>
        <p:spPr>
          <a:xfrm>
            <a:off x="13077720" y="4286160"/>
            <a:ext cx="39060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Arial"/>
                <a:ea typeface="Arial"/>
              </a:rPr>
              <a:t>+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4" name="TextBox 42"/>
          <p:cNvSpPr/>
          <p:nvPr/>
        </p:nvSpPr>
        <p:spPr>
          <a:xfrm>
            <a:off x="11304000" y="3656160"/>
            <a:ext cx="1022040" cy="48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300" spc="-1" strike="noStrike">
                <a:solidFill>
                  <a:srgbClr val="000000"/>
                </a:solidFill>
                <a:latin typeface="Arial"/>
                <a:ea typeface="Arial"/>
              </a:rPr>
              <a:t>BRx140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300" spc="-1" strike="noStrike">
                <a:solidFill>
                  <a:srgbClr val="000000"/>
                </a:solidFill>
                <a:latin typeface="Arial"/>
                <a:ea typeface="Arial"/>
              </a:rPr>
              <a:t>HER2 MUT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5" name="TextBox 44"/>
          <p:cNvSpPr/>
          <p:nvPr/>
        </p:nvSpPr>
        <p:spPr>
          <a:xfrm>
            <a:off x="12374640" y="3656160"/>
            <a:ext cx="990360" cy="48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300" spc="-1" strike="noStrike">
                <a:solidFill>
                  <a:srgbClr val="000000"/>
                </a:solidFill>
                <a:latin typeface="Arial"/>
                <a:ea typeface="Arial"/>
              </a:rPr>
              <a:t>BRx50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300" spc="-1" strike="noStrike">
                <a:solidFill>
                  <a:srgbClr val="000000"/>
                </a:solidFill>
                <a:latin typeface="Arial"/>
                <a:ea typeface="Arial"/>
              </a:rPr>
              <a:t>HER2 WT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6" name="Rectangle 67"/>
          <p:cNvSpPr/>
          <p:nvPr/>
        </p:nvSpPr>
        <p:spPr>
          <a:xfrm flipV="1">
            <a:off x="11323800" y="4107600"/>
            <a:ext cx="1009440" cy="5580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9000" bIns="90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7" name="Rectangle 68"/>
          <p:cNvSpPr/>
          <p:nvPr/>
        </p:nvSpPr>
        <p:spPr>
          <a:xfrm flipV="1">
            <a:off x="12391920" y="4107600"/>
            <a:ext cx="1011240" cy="5580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9000" bIns="90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8" name="TextBox 58"/>
          <p:cNvSpPr/>
          <p:nvPr/>
        </p:nvSpPr>
        <p:spPr>
          <a:xfrm>
            <a:off x="10002960" y="5357880"/>
            <a:ext cx="114444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Arial"/>
                <a:ea typeface="Arial"/>
              </a:rPr>
              <a:t>37kDa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9" name="TextBox 65"/>
          <p:cNvSpPr/>
          <p:nvPr/>
        </p:nvSpPr>
        <p:spPr>
          <a:xfrm>
            <a:off x="13424040" y="5064120"/>
            <a:ext cx="162216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Arial"/>
                <a:ea typeface="Arial"/>
              </a:rPr>
              <a:t>Phospho-ERK1/2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0" name="TextBox 58"/>
          <p:cNvSpPr/>
          <p:nvPr/>
        </p:nvSpPr>
        <p:spPr>
          <a:xfrm>
            <a:off x="13528800" y="5321160"/>
            <a:ext cx="114444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Arial"/>
                <a:ea typeface="Arial"/>
              </a:rPr>
              <a:t>42-44kDa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1" name="TextBox 58"/>
          <p:cNvSpPr/>
          <p:nvPr/>
        </p:nvSpPr>
        <p:spPr>
          <a:xfrm>
            <a:off x="10018800" y="5121360"/>
            <a:ext cx="114444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Arial"/>
                <a:ea typeface="Arial"/>
              </a:rPr>
              <a:t>50kDa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2" name="TextBox 58"/>
          <p:cNvSpPr/>
          <p:nvPr/>
        </p:nvSpPr>
        <p:spPr>
          <a:xfrm>
            <a:off x="10018800" y="4740120"/>
            <a:ext cx="114444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Arial"/>
                <a:ea typeface="Arial"/>
              </a:rPr>
              <a:t>75kDa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3" name="TextBox 58"/>
          <p:cNvSpPr/>
          <p:nvPr/>
        </p:nvSpPr>
        <p:spPr>
          <a:xfrm>
            <a:off x="9941040" y="4522680"/>
            <a:ext cx="114444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Arial"/>
                <a:ea typeface="Arial"/>
              </a:rPr>
              <a:t>100kDa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144" name="Straight Arrow Connector 75"/>
          <p:cNvCxnSpPr/>
          <p:nvPr/>
        </p:nvCxnSpPr>
        <p:spPr>
          <a:xfrm>
            <a:off x="10037880" y="5358960"/>
            <a:ext cx="1165680" cy="11880"/>
          </a:xfrm>
          <a:prstGeom prst="straightConnector1">
            <a:avLst/>
          </a:prstGeom>
          <a:ln w="41400">
            <a:solidFill>
              <a:srgbClr val="ff0000"/>
            </a:solidFill>
            <a:miter/>
            <a:tailEnd len="med" type="triangle" w="med"/>
          </a:ln>
        </p:spPr>
      </p:cxnSp>
      <p:grpSp>
        <p:nvGrpSpPr>
          <p:cNvPr id="145" name="Group 77"/>
          <p:cNvGrpSpPr/>
          <p:nvPr/>
        </p:nvGrpSpPr>
        <p:grpSpPr>
          <a:xfrm>
            <a:off x="5019840" y="6719760"/>
            <a:ext cx="4748040" cy="2005200"/>
            <a:chOff x="5019840" y="6719760"/>
            <a:chExt cx="4748040" cy="2005200"/>
          </a:xfrm>
        </p:grpSpPr>
        <p:pic>
          <p:nvPicPr>
            <p:cNvPr id="146" name="Picture 29" descr=""/>
            <p:cNvPicPr/>
            <p:nvPr/>
          </p:nvPicPr>
          <p:blipFill>
            <a:blip r:embed="rId5"/>
            <a:srcRect l="52772" t="69363" r="5147" b="19682"/>
            <a:stretch/>
          </p:blipFill>
          <p:spPr>
            <a:xfrm>
              <a:off x="5968440" y="7643520"/>
              <a:ext cx="2576880" cy="1081440"/>
            </a:xfrm>
            <a:prstGeom prst="rect">
              <a:avLst/>
            </a:prstGeom>
            <a:ln w="12600">
              <a:solidFill>
                <a:srgbClr val="000000"/>
              </a:solidFill>
              <a:miter/>
            </a:ln>
          </p:spPr>
        </p:pic>
        <p:sp>
          <p:nvSpPr>
            <p:cNvPr id="147" name="TextBox 37"/>
            <p:cNvSpPr/>
            <p:nvPr/>
          </p:nvSpPr>
          <p:spPr>
            <a:xfrm>
              <a:off x="5564160" y="7350120"/>
              <a:ext cx="90000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  <a:ea typeface="Arial"/>
                </a:rPr>
                <a:t>Neratinib</a:t>
              </a:r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8" name="TextBox 38"/>
            <p:cNvSpPr/>
            <p:nvPr/>
          </p:nvSpPr>
          <p:spPr>
            <a:xfrm>
              <a:off x="6504120" y="7350120"/>
              <a:ext cx="39348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  <a:ea typeface="Arial"/>
                </a:rPr>
                <a:t>-</a:t>
              </a:r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9" name="TextBox 39"/>
            <p:cNvSpPr/>
            <p:nvPr/>
          </p:nvSpPr>
          <p:spPr>
            <a:xfrm>
              <a:off x="7069320" y="7350120"/>
              <a:ext cx="39024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0" name="TextBox 40"/>
            <p:cNvSpPr/>
            <p:nvPr/>
          </p:nvSpPr>
          <p:spPr>
            <a:xfrm>
              <a:off x="7589880" y="7350120"/>
              <a:ext cx="39204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  <a:ea typeface="Arial"/>
                </a:rPr>
                <a:t>-</a:t>
              </a:r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1" name="TextBox 41"/>
            <p:cNvSpPr/>
            <p:nvPr/>
          </p:nvSpPr>
          <p:spPr>
            <a:xfrm>
              <a:off x="8156520" y="7350120"/>
              <a:ext cx="38880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2" name="TextBox 42"/>
            <p:cNvSpPr/>
            <p:nvPr/>
          </p:nvSpPr>
          <p:spPr>
            <a:xfrm>
              <a:off x="6446160" y="6719760"/>
              <a:ext cx="1022040" cy="489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300" spc="-1" strike="noStrike">
                  <a:solidFill>
                    <a:srgbClr val="000000"/>
                  </a:solidFill>
                  <a:latin typeface="Arial"/>
                  <a:ea typeface="Arial"/>
                </a:rPr>
                <a:t>BRx140</a:t>
              </a:r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300" spc="-1" strike="noStrike">
                  <a:solidFill>
                    <a:srgbClr val="000000"/>
                  </a:solidFill>
                  <a:latin typeface="Arial"/>
                  <a:ea typeface="Arial"/>
                </a:rPr>
                <a:t>HER2 MUT</a:t>
              </a:r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3" name="TextBox 44"/>
            <p:cNvSpPr/>
            <p:nvPr/>
          </p:nvSpPr>
          <p:spPr>
            <a:xfrm>
              <a:off x="7516800" y="6719760"/>
              <a:ext cx="990360" cy="489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300" spc="-1" strike="noStrike">
                  <a:solidFill>
                    <a:srgbClr val="000000"/>
                  </a:solidFill>
                  <a:latin typeface="Arial"/>
                  <a:ea typeface="Arial"/>
                </a:rPr>
                <a:t>BRx50</a:t>
              </a:r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300" spc="-1" strike="noStrike">
                  <a:solidFill>
                    <a:srgbClr val="000000"/>
                  </a:solidFill>
                  <a:latin typeface="Arial"/>
                  <a:ea typeface="Arial"/>
                </a:rPr>
                <a:t>HER2 WT</a:t>
              </a:r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4" name="Rectangle 86"/>
            <p:cNvSpPr/>
            <p:nvPr/>
          </p:nvSpPr>
          <p:spPr>
            <a:xfrm flipV="1">
              <a:off x="6465960" y="7172280"/>
              <a:ext cx="1009440" cy="5544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8640" bIns="864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5" name="Rectangle 87"/>
            <p:cNvSpPr/>
            <p:nvPr/>
          </p:nvSpPr>
          <p:spPr>
            <a:xfrm flipV="1">
              <a:off x="7534440" y="7172280"/>
              <a:ext cx="1011240" cy="5544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8640" bIns="864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6" name="TextBox 64"/>
            <p:cNvSpPr/>
            <p:nvPr/>
          </p:nvSpPr>
          <p:spPr>
            <a:xfrm>
              <a:off x="8050320" y="7958160"/>
              <a:ext cx="135396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  <a:ea typeface="Arial"/>
                </a:rPr>
                <a:t>ERK1/2</a:t>
              </a:r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7" name="TextBox 58"/>
            <p:cNvSpPr/>
            <p:nvPr/>
          </p:nvSpPr>
          <p:spPr>
            <a:xfrm>
              <a:off x="8623440" y="8205840"/>
              <a:ext cx="114444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  <a:ea typeface="Arial"/>
                </a:rPr>
                <a:t>42-44kDa</a:t>
              </a:r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8" name="TextBox 58"/>
            <p:cNvSpPr/>
            <p:nvPr/>
          </p:nvSpPr>
          <p:spPr>
            <a:xfrm>
              <a:off x="5305320" y="8347320"/>
              <a:ext cx="114444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  <a:ea typeface="Arial"/>
                </a:rPr>
                <a:t>37kDa</a:t>
              </a:r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9" name="TextBox 58"/>
            <p:cNvSpPr/>
            <p:nvPr/>
          </p:nvSpPr>
          <p:spPr>
            <a:xfrm>
              <a:off x="5319720" y="7958160"/>
              <a:ext cx="114444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  <a:ea typeface="Arial"/>
                </a:rPr>
                <a:t>50kDa</a:t>
              </a:r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0" name="TextBox 58"/>
            <p:cNvSpPr/>
            <p:nvPr/>
          </p:nvSpPr>
          <p:spPr>
            <a:xfrm>
              <a:off x="5319720" y="7580160"/>
              <a:ext cx="114444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  <a:ea typeface="Arial"/>
                </a:rPr>
                <a:t>75kDa</a:t>
              </a:r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cxnSp>
          <p:nvCxnSpPr>
            <p:cNvPr id="161" name="Straight Arrow Connector 93"/>
            <p:cNvCxnSpPr/>
            <p:nvPr/>
          </p:nvCxnSpPr>
          <p:spPr>
            <a:xfrm>
              <a:off x="5019840" y="8345520"/>
              <a:ext cx="1165680" cy="11520"/>
            </a:xfrm>
            <a:prstGeom prst="straightConnector1">
              <a:avLst/>
            </a:prstGeom>
            <a:ln w="41400">
              <a:solidFill>
                <a:srgbClr val="ff0000"/>
              </a:solidFill>
              <a:miter/>
              <a:tailEnd len="med" type="triangle" w="med"/>
            </a:ln>
          </p:spPr>
        </p:cxnSp>
      </p:grpSp>
      <p:grpSp>
        <p:nvGrpSpPr>
          <p:cNvPr id="162" name="Group 94"/>
          <p:cNvGrpSpPr/>
          <p:nvPr/>
        </p:nvGrpSpPr>
        <p:grpSpPr>
          <a:xfrm>
            <a:off x="9873720" y="6180120"/>
            <a:ext cx="5037840" cy="2836800"/>
            <a:chOff x="9873720" y="6180120"/>
            <a:chExt cx="5037840" cy="2836800"/>
          </a:xfrm>
        </p:grpSpPr>
        <p:pic>
          <p:nvPicPr>
            <p:cNvPr id="163" name="Picture 62" descr=""/>
            <p:cNvPicPr/>
            <p:nvPr/>
          </p:nvPicPr>
          <p:blipFill>
            <a:blip r:embed="rId6"/>
            <a:srcRect l="4429" t="75836" r="78157" b="17694"/>
            <a:stretch/>
          </p:blipFill>
          <p:spPr>
            <a:xfrm>
              <a:off x="10807920" y="7103520"/>
              <a:ext cx="2684880" cy="1913400"/>
            </a:xfrm>
            <a:prstGeom prst="rect">
              <a:avLst/>
            </a:prstGeom>
            <a:ln w="12600">
              <a:solidFill>
                <a:srgbClr val="000000"/>
              </a:solidFill>
              <a:miter/>
            </a:ln>
          </p:spPr>
        </p:pic>
        <p:sp>
          <p:nvSpPr>
            <p:cNvPr id="164" name="TextBox 59"/>
            <p:cNvSpPr/>
            <p:nvPr/>
          </p:nvSpPr>
          <p:spPr>
            <a:xfrm>
              <a:off x="13528800" y="7621560"/>
              <a:ext cx="1382760" cy="489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792000"/>
                  <a:tab algn="l" pos="1584360"/>
                  <a:tab algn="l" pos="2376360"/>
                  <a:tab algn="l" pos="3168720"/>
                  <a:tab algn="l" pos="3960720"/>
                  <a:tab algn="l" pos="4753080"/>
                  <a:tab algn="l" pos="5545080"/>
                  <a:tab algn="l" pos="6337440"/>
                  <a:tab algn="l" pos="7129440"/>
                  <a:tab algn="l" pos="7921800"/>
                  <a:tab algn="l" pos="8713800"/>
                  <a:tab algn="l" pos="9505800"/>
                  <a:tab algn="l" pos="1029816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  <a:ea typeface="Arial"/>
                </a:rPr>
                <a:t>GAPDH</a:t>
              </a:r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792000"/>
                  <a:tab algn="l" pos="1584360"/>
                  <a:tab algn="l" pos="2376360"/>
                  <a:tab algn="l" pos="3168720"/>
                  <a:tab algn="l" pos="3960720"/>
                  <a:tab algn="l" pos="4753080"/>
                  <a:tab algn="l" pos="5545080"/>
                  <a:tab algn="l" pos="6337440"/>
                  <a:tab algn="l" pos="7129440"/>
                  <a:tab algn="l" pos="7921800"/>
                  <a:tab algn="l" pos="8713800"/>
                  <a:tab algn="l" pos="9505800"/>
                  <a:tab algn="l" pos="1029816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  <a:ea typeface="Arial"/>
                </a:rPr>
                <a:t>37kDA</a:t>
              </a:r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cxnSp>
          <p:nvCxnSpPr>
            <p:cNvPr id="165" name="Straight Arrow Connector 97"/>
            <p:cNvCxnSpPr/>
            <p:nvPr/>
          </p:nvCxnSpPr>
          <p:spPr>
            <a:xfrm>
              <a:off x="9873720" y="7503120"/>
              <a:ext cx="1166040" cy="12240"/>
            </a:xfrm>
            <a:prstGeom prst="straightConnector1">
              <a:avLst/>
            </a:prstGeom>
            <a:ln w="41400">
              <a:solidFill>
                <a:srgbClr val="ff0000"/>
              </a:solidFill>
              <a:miter/>
              <a:tailEnd len="med" type="triangle" w="med"/>
            </a:ln>
          </p:spPr>
        </p:cxnSp>
        <p:sp>
          <p:nvSpPr>
            <p:cNvPr id="166" name="TextBox 58"/>
            <p:cNvSpPr/>
            <p:nvPr/>
          </p:nvSpPr>
          <p:spPr>
            <a:xfrm>
              <a:off x="10105560" y="7219800"/>
              <a:ext cx="114444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792000"/>
                  <a:tab algn="l" pos="1584360"/>
                  <a:tab algn="l" pos="2376360"/>
                  <a:tab algn="l" pos="3168720"/>
                  <a:tab algn="l" pos="3960720"/>
                  <a:tab algn="l" pos="4753080"/>
                  <a:tab algn="l" pos="5545080"/>
                  <a:tab algn="l" pos="6337440"/>
                  <a:tab algn="l" pos="7129440"/>
                  <a:tab algn="l" pos="7921800"/>
                  <a:tab algn="l" pos="8713800"/>
                  <a:tab algn="l" pos="9505800"/>
                  <a:tab algn="l" pos="1029816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  <a:ea typeface="Arial"/>
                </a:rPr>
                <a:t>37kDa</a:t>
              </a:r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7" name="TextBox 58"/>
            <p:cNvSpPr/>
            <p:nvPr/>
          </p:nvSpPr>
          <p:spPr>
            <a:xfrm>
              <a:off x="10105560" y="8450280"/>
              <a:ext cx="114444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792000"/>
                  <a:tab algn="l" pos="1584360"/>
                  <a:tab algn="l" pos="2376360"/>
                  <a:tab algn="l" pos="3168720"/>
                  <a:tab algn="l" pos="3960720"/>
                  <a:tab algn="l" pos="4753080"/>
                  <a:tab algn="l" pos="5545080"/>
                  <a:tab algn="l" pos="6337440"/>
                  <a:tab algn="l" pos="7129440"/>
                  <a:tab algn="l" pos="7921800"/>
                  <a:tab algn="l" pos="8713800"/>
                  <a:tab algn="l" pos="9505800"/>
                  <a:tab algn="l" pos="1029816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  <a:ea typeface="Arial"/>
                </a:rPr>
                <a:t>20kDa</a:t>
              </a:r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8" name="TextBox 58"/>
            <p:cNvSpPr/>
            <p:nvPr/>
          </p:nvSpPr>
          <p:spPr>
            <a:xfrm>
              <a:off x="10105560" y="8155080"/>
              <a:ext cx="114444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792000"/>
                  <a:tab algn="l" pos="1584360"/>
                  <a:tab algn="l" pos="2376360"/>
                  <a:tab algn="l" pos="3168720"/>
                  <a:tab algn="l" pos="3960720"/>
                  <a:tab algn="l" pos="4753080"/>
                  <a:tab algn="l" pos="5545080"/>
                  <a:tab algn="l" pos="6337440"/>
                  <a:tab algn="l" pos="7129440"/>
                  <a:tab algn="l" pos="7921800"/>
                  <a:tab algn="l" pos="8713800"/>
                  <a:tab algn="l" pos="9505800"/>
                  <a:tab algn="l" pos="1029816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  <a:ea typeface="Arial"/>
                </a:rPr>
                <a:t>25kDa</a:t>
              </a:r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9" name="TextBox 37"/>
            <p:cNvSpPr/>
            <p:nvPr/>
          </p:nvSpPr>
          <p:spPr>
            <a:xfrm>
              <a:off x="10358280" y="6810120"/>
              <a:ext cx="90000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792000"/>
                  <a:tab algn="l" pos="1584360"/>
                  <a:tab algn="l" pos="2376360"/>
                  <a:tab algn="l" pos="3168720"/>
                  <a:tab algn="l" pos="3960720"/>
                  <a:tab algn="l" pos="4753080"/>
                  <a:tab algn="l" pos="5545080"/>
                  <a:tab algn="l" pos="6337440"/>
                  <a:tab algn="l" pos="7129440"/>
                  <a:tab algn="l" pos="7921800"/>
                  <a:tab algn="l" pos="8713800"/>
                  <a:tab algn="l" pos="9505800"/>
                  <a:tab algn="l" pos="1029816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  <a:ea typeface="Arial"/>
                </a:rPr>
                <a:t>Neratinib</a:t>
              </a:r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0" name="TextBox 38"/>
            <p:cNvSpPr/>
            <p:nvPr/>
          </p:nvSpPr>
          <p:spPr>
            <a:xfrm>
              <a:off x="11471040" y="6810120"/>
              <a:ext cx="39348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792000"/>
                  <a:tab algn="l" pos="1584360"/>
                  <a:tab algn="l" pos="2376360"/>
                  <a:tab algn="l" pos="3168720"/>
                  <a:tab algn="l" pos="3960720"/>
                  <a:tab algn="l" pos="4753080"/>
                  <a:tab algn="l" pos="5545080"/>
                  <a:tab algn="l" pos="6337440"/>
                  <a:tab algn="l" pos="7129440"/>
                  <a:tab algn="l" pos="7921800"/>
                  <a:tab algn="l" pos="8713800"/>
                  <a:tab algn="l" pos="9505800"/>
                  <a:tab algn="l" pos="1029816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  <a:ea typeface="Arial"/>
                </a:rPr>
                <a:t>-</a:t>
              </a:r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1" name="TextBox 39"/>
            <p:cNvSpPr/>
            <p:nvPr/>
          </p:nvSpPr>
          <p:spPr>
            <a:xfrm>
              <a:off x="11971440" y="6810120"/>
              <a:ext cx="39024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792000"/>
                  <a:tab algn="l" pos="1584360"/>
                  <a:tab algn="l" pos="2376360"/>
                  <a:tab algn="l" pos="3168720"/>
                  <a:tab algn="l" pos="3960720"/>
                  <a:tab algn="l" pos="4753080"/>
                  <a:tab algn="l" pos="5545080"/>
                  <a:tab algn="l" pos="6337440"/>
                  <a:tab algn="l" pos="7129440"/>
                  <a:tab algn="l" pos="7921800"/>
                  <a:tab algn="l" pos="8713800"/>
                  <a:tab algn="l" pos="9505800"/>
                  <a:tab algn="l" pos="1029816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2" name="TextBox 40"/>
            <p:cNvSpPr/>
            <p:nvPr/>
          </p:nvSpPr>
          <p:spPr>
            <a:xfrm>
              <a:off x="12384000" y="6810120"/>
              <a:ext cx="39024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792000"/>
                  <a:tab algn="l" pos="1584360"/>
                  <a:tab algn="l" pos="2376360"/>
                  <a:tab algn="l" pos="3168720"/>
                  <a:tab algn="l" pos="3960720"/>
                  <a:tab algn="l" pos="4753080"/>
                  <a:tab algn="l" pos="5545080"/>
                  <a:tab algn="l" pos="6337440"/>
                  <a:tab algn="l" pos="7129440"/>
                  <a:tab algn="l" pos="7921800"/>
                  <a:tab algn="l" pos="8713800"/>
                  <a:tab algn="l" pos="9505800"/>
                  <a:tab algn="l" pos="1029816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  <a:ea typeface="Arial"/>
                </a:rPr>
                <a:t>-</a:t>
              </a:r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3" name="TextBox 41"/>
            <p:cNvSpPr/>
            <p:nvPr/>
          </p:nvSpPr>
          <p:spPr>
            <a:xfrm>
              <a:off x="13025520" y="6810120"/>
              <a:ext cx="39024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792000"/>
                  <a:tab algn="l" pos="1584360"/>
                  <a:tab algn="l" pos="2376360"/>
                  <a:tab algn="l" pos="3168720"/>
                  <a:tab algn="l" pos="3960720"/>
                  <a:tab algn="l" pos="4753080"/>
                  <a:tab algn="l" pos="5545080"/>
                  <a:tab algn="l" pos="6337440"/>
                  <a:tab algn="l" pos="7129440"/>
                  <a:tab algn="l" pos="7921800"/>
                  <a:tab algn="l" pos="8713800"/>
                  <a:tab algn="l" pos="9505800"/>
                  <a:tab algn="l" pos="1029816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4" name="TextBox 42"/>
            <p:cNvSpPr/>
            <p:nvPr/>
          </p:nvSpPr>
          <p:spPr>
            <a:xfrm>
              <a:off x="11239920" y="6180120"/>
              <a:ext cx="1022040" cy="489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792000"/>
                  <a:tab algn="l" pos="1584360"/>
                  <a:tab algn="l" pos="2376360"/>
                  <a:tab algn="l" pos="3168720"/>
                  <a:tab algn="l" pos="3960720"/>
                  <a:tab algn="l" pos="4753080"/>
                  <a:tab algn="l" pos="5545080"/>
                  <a:tab algn="l" pos="6337440"/>
                  <a:tab algn="l" pos="7129440"/>
                  <a:tab algn="l" pos="7921800"/>
                  <a:tab algn="l" pos="8713800"/>
                  <a:tab algn="l" pos="9505800"/>
                  <a:tab algn="l" pos="10298160"/>
                </a:tabLst>
              </a:pPr>
              <a:r>
                <a:rPr b="1" lang="en-US" sz="1300" spc="-1" strike="noStrike">
                  <a:solidFill>
                    <a:srgbClr val="000000"/>
                  </a:solidFill>
                  <a:latin typeface="Arial"/>
                  <a:ea typeface="Arial"/>
                </a:rPr>
                <a:t>BRx140</a:t>
              </a:r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792000"/>
                  <a:tab algn="l" pos="1584360"/>
                  <a:tab algn="l" pos="2376360"/>
                  <a:tab algn="l" pos="3168720"/>
                  <a:tab algn="l" pos="3960720"/>
                  <a:tab algn="l" pos="4753080"/>
                  <a:tab algn="l" pos="5545080"/>
                  <a:tab algn="l" pos="6337440"/>
                  <a:tab algn="l" pos="7129440"/>
                  <a:tab algn="l" pos="7921800"/>
                  <a:tab algn="l" pos="8713800"/>
                  <a:tab algn="l" pos="9505800"/>
                  <a:tab algn="l" pos="10298160"/>
                </a:tabLst>
              </a:pPr>
              <a:r>
                <a:rPr b="1" lang="en-US" sz="1300" spc="-1" strike="noStrike">
                  <a:solidFill>
                    <a:srgbClr val="000000"/>
                  </a:solidFill>
                  <a:latin typeface="Arial"/>
                  <a:ea typeface="Arial"/>
                </a:rPr>
                <a:t>HER2 MUT</a:t>
              </a:r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5" name="TextBox 44"/>
            <p:cNvSpPr/>
            <p:nvPr/>
          </p:nvSpPr>
          <p:spPr>
            <a:xfrm>
              <a:off x="12310920" y="6180120"/>
              <a:ext cx="990720" cy="489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792000"/>
                  <a:tab algn="l" pos="1584360"/>
                  <a:tab algn="l" pos="2376360"/>
                  <a:tab algn="l" pos="3168720"/>
                  <a:tab algn="l" pos="3960720"/>
                  <a:tab algn="l" pos="4753080"/>
                  <a:tab algn="l" pos="5545080"/>
                  <a:tab algn="l" pos="6337440"/>
                  <a:tab algn="l" pos="7129440"/>
                  <a:tab algn="l" pos="7921800"/>
                  <a:tab algn="l" pos="8713800"/>
                  <a:tab algn="l" pos="9505800"/>
                  <a:tab algn="l" pos="10298160"/>
                </a:tabLst>
              </a:pPr>
              <a:r>
                <a:rPr b="1" lang="en-US" sz="1300" spc="-1" strike="noStrike">
                  <a:solidFill>
                    <a:srgbClr val="000000"/>
                  </a:solidFill>
                  <a:latin typeface="Arial"/>
                  <a:ea typeface="Arial"/>
                </a:rPr>
                <a:t>BRx50</a:t>
              </a:r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792000"/>
                  <a:tab algn="l" pos="1584360"/>
                  <a:tab algn="l" pos="2376360"/>
                  <a:tab algn="l" pos="3168720"/>
                  <a:tab algn="l" pos="3960720"/>
                  <a:tab algn="l" pos="4753080"/>
                  <a:tab algn="l" pos="5545080"/>
                  <a:tab algn="l" pos="6337440"/>
                  <a:tab algn="l" pos="7129440"/>
                  <a:tab algn="l" pos="7921800"/>
                  <a:tab algn="l" pos="8713800"/>
                  <a:tab algn="l" pos="9505800"/>
                  <a:tab algn="l" pos="10298160"/>
                </a:tabLst>
              </a:pPr>
              <a:r>
                <a:rPr b="1" lang="en-US" sz="1300" spc="-1" strike="noStrike">
                  <a:solidFill>
                    <a:srgbClr val="000000"/>
                  </a:solidFill>
                  <a:latin typeface="Arial"/>
                  <a:ea typeface="Arial"/>
                </a:rPr>
                <a:t>HER2 WT</a:t>
              </a:r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6" name="Rectangle 108"/>
            <p:cNvSpPr/>
            <p:nvPr/>
          </p:nvSpPr>
          <p:spPr>
            <a:xfrm flipV="1">
              <a:off x="11260080" y="6632280"/>
              <a:ext cx="1009440" cy="5544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8640" bIns="8640" anchor="ctr">
              <a:noAutofit/>
            </a:bodyPr>
            <a:p>
              <a:pPr algn="ctr">
                <a:tabLst>
                  <a:tab algn="l" pos="0"/>
                  <a:tab algn="l" pos="792000"/>
                  <a:tab algn="l" pos="1584360"/>
                  <a:tab algn="l" pos="2376360"/>
                  <a:tab algn="l" pos="3168720"/>
                  <a:tab algn="l" pos="3960720"/>
                  <a:tab algn="l" pos="4753080"/>
                  <a:tab algn="l" pos="5545080"/>
                  <a:tab algn="l" pos="6337440"/>
                  <a:tab algn="l" pos="7129440"/>
                  <a:tab algn="l" pos="7921800"/>
                  <a:tab algn="l" pos="8713800"/>
                  <a:tab algn="l" pos="9505800"/>
                  <a:tab algn="l" pos="1029816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7" name="Rectangle 109"/>
            <p:cNvSpPr/>
            <p:nvPr/>
          </p:nvSpPr>
          <p:spPr>
            <a:xfrm flipV="1">
              <a:off x="12328560" y="6632280"/>
              <a:ext cx="1011240" cy="5544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8640" bIns="8640" anchor="ctr">
              <a:noAutofit/>
            </a:bodyPr>
            <a:p>
              <a:pPr algn="ctr">
                <a:tabLst>
                  <a:tab algn="l" pos="0"/>
                  <a:tab algn="l" pos="792000"/>
                  <a:tab algn="l" pos="1584360"/>
                  <a:tab algn="l" pos="2376360"/>
                  <a:tab algn="l" pos="3168720"/>
                  <a:tab algn="l" pos="3960720"/>
                  <a:tab algn="l" pos="4753080"/>
                  <a:tab algn="l" pos="5545080"/>
                  <a:tab algn="l" pos="6337440"/>
                  <a:tab algn="l" pos="7129440"/>
                  <a:tab algn="l" pos="7921800"/>
                  <a:tab algn="l" pos="8713800"/>
                  <a:tab algn="l" pos="9505800"/>
                  <a:tab algn="l" pos="1029816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78" name="TextBox 11"/>
          <p:cNvSpPr/>
          <p:nvPr/>
        </p:nvSpPr>
        <p:spPr>
          <a:xfrm>
            <a:off x="141480" y="541440"/>
            <a:ext cx="4487400" cy="2284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2: 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600" spc="-1" strike="noStrike">
                <a:solidFill>
                  <a:srgbClr val="000000"/>
                </a:solidFill>
                <a:latin typeface="Calibri"/>
              </a:rPr>
              <a:t>The CTC cell lines (BRx140 and BRx50) were treated 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600" spc="-1" strike="noStrike">
                <a:solidFill>
                  <a:srgbClr val="000000"/>
                </a:solidFill>
                <a:latin typeface="Calibri"/>
              </a:rPr>
              <a:t>with 100nM neratinib for 24hrs and proteins were 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600" spc="-1" strike="noStrike">
                <a:solidFill>
                  <a:srgbClr val="000000"/>
                </a:solidFill>
                <a:latin typeface="Calibri"/>
              </a:rPr>
              <a:t>analyzed for HER2, phopho-S6, and phosho-ERK1/2 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600" spc="-1" strike="noStrike">
                <a:solidFill>
                  <a:srgbClr val="000000"/>
                </a:solidFill>
                <a:latin typeface="Calibri"/>
              </a:rPr>
              <a:t>expression. Total S6 and ERK1/2 are shown. 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600" spc="-1" strike="noStrike">
                <a:solidFill>
                  <a:srgbClr val="000000"/>
                </a:solidFill>
                <a:latin typeface="Calibri"/>
              </a:rPr>
              <a:t>GAPDH was analyzed as control for equal loading of 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600" spc="-1" strike="noStrike">
                <a:solidFill>
                  <a:srgbClr val="000000"/>
                </a:solidFill>
                <a:latin typeface="Calibri"/>
              </a:rPr>
              <a:t>proteins. The uncropped scans depict the 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600" spc="-1" strike="noStrike">
                <a:solidFill>
                  <a:srgbClr val="000000"/>
                </a:solidFill>
                <a:latin typeface="Calibri"/>
              </a:rPr>
              <a:t>raw blots with the ladder and 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600" spc="-1" strike="noStrike">
                <a:solidFill>
                  <a:srgbClr val="000000"/>
                </a:solidFill>
                <a:latin typeface="Calibri"/>
              </a:rPr>
              <a:t>molecular weight/size markers. 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9" name="TextBox 11"/>
          <p:cNvSpPr/>
          <p:nvPr/>
        </p:nvSpPr>
        <p:spPr>
          <a:xfrm>
            <a:off x="186840" y="285840"/>
            <a:ext cx="449064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Supplementary Table 1A: </a:t>
            </a: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Patient characteristics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180" name=""/>
          <p:cNvGraphicFramePr/>
          <p:nvPr/>
        </p:nvGraphicFramePr>
        <p:xfrm>
          <a:off x="2398680" y="2593800"/>
          <a:ext cx="3708360" cy="1922760"/>
        </p:xfrm>
        <a:graphic>
          <a:graphicData uri="http://schemas.openxmlformats.org/drawingml/2006/table">
            <a:tbl>
              <a:tblPr/>
              <a:tblGrid>
                <a:gridCol w="2881440"/>
                <a:gridCol w="826920"/>
              </a:tblGrid>
              <a:tr h="254160">
                <a:tc gridSpan="2"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1170000"/>
                          <a:tab algn="l" pos="2340000"/>
                          <a:tab algn="l" pos="3510000"/>
                          <a:tab algn="l" pos="4680000"/>
                          <a:tab algn="l" pos="5850000"/>
                          <a:tab algn="l" pos="7020000"/>
                          <a:tab algn="l" pos="8190000"/>
                          <a:tab algn="l" pos="9360000"/>
                          <a:tab algn="l" pos="105300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Rx14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fbfb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238320"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1170000"/>
                          <a:tab algn="l" pos="2340000"/>
                          <a:tab algn="l" pos="3510000"/>
                          <a:tab algn="l" pos="4680000"/>
                          <a:tab algn="l" pos="5850000"/>
                          <a:tab algn="l" pos="7020000"/>
                          <a:tab algn="l" pos="8190000"/>
                          <a:tab algn="l" pos="9360000"/>
                          <a:tab algn="l" pos="10530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ge at Primary Diagnosi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1170000"/>
                          <a:tab algn="l" pos="2340000"/>
                          <a:tab algn="l" pos="3510000"/>
                          <a:tab algn="l" pos="4680000"/>
                          <a:tab algn="l" pos="5850000"/>
                          <a:tab algn="l" pos="7020000"/>
                          <a:tab algn="l" pos="8190000"/>
                          <a:tab algn="l" pos="9360000"/>
                          <a:tab algn="l" pos="10530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37960"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1170000"/>
                          <a:tab algn="l" pos="2340000"/>
                          <a:tab algn="l" pos="3510000"/>
                          <a:tab algn="l" pos="4680000"/>
                          <a:tab algn="l" pos="5850000"/>
                          <a:tab algn="l" pos="7020000"/>
                          <a:tab algn="l" pos="8190000"/>
                          <a:tab algn="l" pos="9360000"/>
                          <a:tab algn="l" pos="10530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ge at Metastatic Diagnosi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1170000"/>
                          <a:tab algn="l" pos="2340000"/>
                          <a:tab algn="l" pos="3510000"/>
                          <a:tab algn="l" pos="4680000"/>
                          <a:tab algn="l" pos="5850000"/>
                          <a:tab algn="l" pos="7020000"/>
                          <a:tab algn="l" pos="8190000"/>
                          <a:tab algn="l" pos="9360000"/>
                          <a:tab algn="l" pos="10530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39760"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1170000"/>
                          <a:tab algn="l" pos="2340000"/>
                          <a:tab algn="l" pos="3510000"/>
                          <a:tab algn="l" pos="4680000"/>
                          <a:tab algn="l" pos="5850000"/>
                          <a:tab algn="l" pos="7020000"/>
                          <a:tab algn="l" pos="8190000"/>
                          <a:tab algn="l" pos="9360000"/>
                          <a:tab algn="l" pos="10530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e Novo Metastasi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1170000"/>
                          <a:tab algn="l" pos="2340000"/>
                          <a:tab algn="l" pos="3510000"/>
                          <a:tab algn="l" pos="4680000"/>
                          <a:tab algn="l" pos="5850000"/>
                          <a:tab algn="l" pos="7020000"/>
                          <a:tab algn="l" pos="8190000"/>
                          <a:tab algn="l" pos="9360000"/>
                          <a:tab algn="l" pos="10530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o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37960"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1170000"/>
                          <a:tab algn="l" pos="2340000"/>
                          <a:tab algn="l" pos="3510000"/>
                          <a:tab algn="l" pos="4680000"/>
                          <a:tab algn="l" pos="5850000"/>
                          <a:tab algn="l" pos="7020000"/>
                          <a:tab algn="l" pos="8190000"/>
                          <a:tab algn="l" pos="9360000"/>
                          <a:tab algn="l" pos="10530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umber of Prior Endocrine Therapie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1170000"/>
                          <a:tab algn="l" pos="2340000"/>
                          <a:tab algn="l" pos="3510000"/>
                          <a:tab algn="l" pos="4680000"/>
                          <a:tab algn="l" pos="5850000"/>
                          <a:tab algn="l" pos="7020000"/>
                          <a:tab algn="l" pos="8190000"/>
                          <a:tab algn="l" pos="9360000"/>
                          <a:tab algn="l" pos="10530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38320"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1170000"/>
                          <a:tab algn="l" pos="2340000"/>
                          <a:tab algn="l" pos="3510000"/>
                          <a:tab algn="l" pos="4680000"/>
                          <a:tab algn="l" pos="5850000"/>
                          <a:tab algn="l" pos="7020000"/>
                          <a:tab algn="l" pos="8190000"/>
                          <a:tab algn="l" pos="9360000"/>
                          <a:tab algn="l" pos="10530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umber of Prior Chemotherapie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1170000"/>
                          <a:tab algn="l" pos="2340000"/>
                          <a:tab algn="l" pos="3510000"/>
                          <a:tab algn="l" pos="4680000"/>
                          <a:tab algn="l" pos="5850000"/>
                          <a:tab algn="l" pos="7020000"/>
                          <a:tab algn="l" pos="8190000"/>
                          <a:tab algn="l" pos="9360000"/>
                          <a:tab algn="l" pos="10530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37960"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1170000"/>
                          <a:tab algn="l" pos="2340000"/>
                          <a:tab algn="l" pos="3510000"/>
                          <a:tab algn="l" pos="4680000"/>
                          <a:tab algn="l" pos="5850000"/>
                          <a:tab algn="l" pos="7020000"/>
                          <a:tab algn="l" pos="8190000"/>
                          <a:tab algn="l" pos="9360000"/>
                          <a:tab algn="l" pos="10530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eceived Prior CDK 4/6 Therapie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1170000"/>
                          <a:tab algn="l" pos="2340000"/>
                          <a:tab algn="l" pos="3510000"/>
                          <a:tab algn="l" pos="4680000"/>
                          <a:tab algn="l" pos="5850000"/>
                          <a:tab algn="l" pos="7020000"/>
                          <a:tab algn="l" pos="8190000"/>
                          <a:tab algn="l" pos="9360000"/>
                          <a:tab algn="l" pos="10530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o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38320"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1170000"/>
                          <a:tab algn="l" pos="2340000"/>
                          <a:tab algn="l" pos="3510000"/>
                          <a:tab algn="l" pos="4680000"/>
                          <a:tab algn="l" pos="5850000"/>
                          <a:tab algn="l" pos="7020000"/>
                          <a:tab algn="l" pos="8190000"/>
                          <a:tab algn="l" pos="9360000"/>
                          <a:tab algn="l" pos="10530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rior Adjuvant Aromatase Inhibitor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1170000"/>
                          <a:tab algn="l" pos="2340000"/>
                          <a:tab algn="l" pos="3510000"/>
                          <a:tab algn="l" pos="4680000"/>
                          <a:tab algn="l" pos="5850000"/>
                          <a:tab algn="l" pos="7020000"/>
                          <a:tab algn="l" pos="8190000"/>
                          <a:tab algn="l" pos="9360000"/>
                          <a:tab algn="l" pos="10530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Ye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181" name=""/>
          <p:cNvGraphicFramePr/>
          <p:nvPr/>
        </p:nvGraphicFramePr>
        <p:xfrm>
          <a:off x="6332400" y="2593800"/>
          <a:ext cx="3708360" cy="1924200"/>
        </p:xfrm>
        <a:graphic>
          <a:graphicData uri="http://schemas.openxmlformats.org/drawingml/2006/table">
            <a:tbl>
              <a:tblPr/>
              <a:tblGrid>
                <a:gridCol w="2854440"/>
                <a:gridCol w="853920"/>
              </a:tblGrid>
              <a:tr h="257400">
                <a:tc gridSpan="2"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1170000"/>
                          <a:tab algn="l" pos="2340000"/>
                          <a:tab algn="l" pos="3510000"/>
                          <a:tab algn="l" pos="4680000"/>
                          <a:tab algn="l" pos="5850000"/>
                          <a:tab algn="l" pos="7020000"/>
                          <a:tab algn="l" pos="8190000"/>
                          <a:tab algn="l" pos="9360000"/>
                          <a:tab algn="l" pos="105300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Rx5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fbfb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237960"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1170000"/>
                          <a:tab algn="l" pos="2340000"/>
                          <a:tab algn="l" pos="3510000"/>
                          <a:tab algn="l" pos="4680000"/>
                          <a:tab algn="l" pos="5850000"/>
                          <a:tab algn="l" pos="7020000"/>
                          <a:tab algn="l" pos="8190000"/>
                          <a:tab algn="l" pos="9360000"/>
                          <a:tab algn="l" pos="10530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ge at Primary Diagnosi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1170000"/>
                          <a:tab algn="l" pos="2340000"/>
                          <a:tab algn="l" pos="3510000"/>
                          <a:tab algn="l" pos="4680000"/>
                          <a:tab algn="l" pos="5850000"/>
                          <a:tab algn="l" pos="7020000"/>
                          <a:tab algn="l" pos="8190000"/>
                          <a:tab algn="l" pos="9360000"/>
                          <a:tab algn="l" pos="10530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38320"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1170000"/>
                          <a:tab algn="l" pos="2340000"/>
                          <a:tab algn="l" pos="3510000"/>
                          <a:tab algn="l" pos="4680000"/>
                          <a:tab algn="l" pos="5850000"/>
                          <a:tab algn="l" pos="7020000"/>
                          <a:tab algn="l" pos="8190000"/>
                          <a:tab algn="l" pos="9360000"/>
                          <a:tab algn="l" pos="10530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ge at Metastatic Diagnosi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1170000"/>
                          <a:tab algn="l" pos="2340000"/>
                          <a:tab algn="l" pos="3510000"/>
                          <a:tab algn="l" pos="4680000"/>
                          <a:tab algn="l" pos="5850000"/>
                          <a:tab algn="l" pos="7020000"/>
                          <a:tab algn="l" pos="8190000"/>
                          <a:tab algn="l" pos="9360000"/>
                          <a:tab algn="l" pos="10530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37960"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1170000"/>
                          <a:tab algn="l" pos="2340000"/>
                          <a:tab algn="l" pos="3510000"/>
                          <a:tab algn="l" pos="4680000"/>
                          <a:tab algn="l" pos="5850000"/>
                          <a:tab algn="l" pos="7020000"/>
                          <a:tab algn="l" pos="8190000"/>
                          <a:tab algn="l" pos="9360000"/>
                          <a:tab algn="l" pos="10530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e Novo Metastasi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1170000"/>
                          <a:tab algn="l" pos="2340000"/>
                          <a:tab algn="l" pos="3510000"/>
                          <a:tab algn="l" pos="4680000"/>
                          <a:tab algn="l" pos="5850000"/>
                          <a:tab algn="l" pos="7020000"/>
                          <a:tab algn="l" pos="8190000"/>
                          <a:tab algn="l" pos="9360000"/>
                          <a:tab algn="l" pos="10530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o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38320"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1170000"/>
                          <a:tab algn="l" pos="2340000"/>
                          <a:tab algn="l" pos="3510000"/>
                          <a:tab algn="l" pos="4680000"/>
                          <a:tab algn="l" pos="5850000"/>
                          <a:tab algn="l" pos="7020000"/>
                          <a:tab algn="l" pos="8190000"/>
                          <a:tab algn="l" pos="9360000"/>
                          <a:tab algn="l" pos="10530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umber of Prior Endocrine Therapie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1170000"/>
                          <a:tab algn="l" pos="2340000"/>
                          <a:tab algn="l" pos="3510000"/>
                          <a:tab algn="l" pos="4680000"/>
                          <a:tab algn="l" pos="5850000"/>
                          <a:tab algn="l" pos="7020000"/>
                          <a:tab algn="l" pos="8190000"/>
                          <a:tab algn="l" pos="9360000"/>
                          <a:tab algn="l" pos="10530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37960"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1170000"/>
                          <a:tab algn="l" pos="2340000"/>
                          <a:tab algn="l" pos="3510000"/>
                          <a:tab algn="l" pos="4680000"/>
                          <a:tab algn="l" pos="5850000"/>
                          <a:tab algn="l" pos="7020000"/>
                          <a:tab algn="l" pos="8190000"/>
                          <a:tab algn="l" pos="9360000"/>
                          <a:tab algn="l" pos="10530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umber of Prior Chemotherapie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1170000"/>
                          <a:tab algn="l" pos="2340000"/>
                          <a:tab algn="l" pos="3510000"/>
                          <a:tab algn="l" pos="4680000"/>
                          <a:tab algn="l" pos="5850000"/>
                          <a:tab algn="l" pos="7020000"/>
                          <a:tab algn="l" pos="8190000"/>
                          <a:tab algn="l" pos="9360000"/>
                          <a:tab algn="l" pos="10530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38320"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1170000"/>
                          <a:tab algn="l" pos="2340000"/>
                          <a:tab algn="l" pos="3510000"/>
                          <a:tab algn="l" pos="4680000"/>
                          <a:tab algn="l" pos="5850000"/>
                          <a:tab algn="l" pos="7020000"/>
                          <a:tab algn="l" pos="8190000"/>
                          <a:tab algn="l" pos="9360000"/>
                          <a:tab algn="l" pos="10530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eceived Prior CDK 4/6 Therapie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1170000"/>
                          <a:tab algn="l" pos="2340000"/>
                          <a:tab algn="l" pos="3510000"/>
                          <a:tab algn="l" pos="4680000"/>
                          <a:tab algn="l" pos="5850000"/>
                          <a:tab algn="l" pos="7020000"/>
                          <a:tab algn="l" pos="8190000"/>
                          <a:tab algn="l" pos="9360000"/>
                          <a:tab algn="l" pos="10530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o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37960"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1170000"/>
                          <a:tab algn="l" pos="2340000"/>
                          <a:tab algn="l" pos="3510000"/>
                          <a:tab algn="l" pos="4680000"/>
                          <a:tab algn="l" pos="5850000"/>
                          <a:tab algn="l" pos="7020000"/>
                          <a:tab algn="l" pos="8190000"/>
                          <a:tab algn="l" pos="9360000"/>
                          <a:tab algn="l" pos="10530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rior Adjuvant Aromatase Inhibitor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1170000"/>
                          <a:tab algn="l" pos="2340000"/>
                          <a:tab algn="l" pos="3510000"/>
                          <a:tab algn="l" pos="4680000"/>
                          <a:tab algn="l" pos="5850000"/>
                          <a:tab algn="l" pos="7020000"/>
                          <a:tab algn="l" pos="8190000"/>
                          <a:tab algn="l" pos="9360000"/>
                          <a:tab algn="l" pos="10530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o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2" name="TextBox 11"/>
          <p:cNvSpPr/>
          <p:nvPr/>
        </p:nvSpPr>
        <p:spPr>
          <a:xfrm>
            <a:off x="423000" y="276120"/>
            <a:ext cx="1031400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Supplementary Table 1B: </a:t>
            </a: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List of additional mutations present in CTC cultures, along with tissue and ctDNA genotyping.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183" name=""/>
          <p:cNvGraphicFramePr/>
          <p:nvPr/>
        </p:nvGraphicFramePr>
        <p:xfrm>
          <a:off x="488880" y="1401840"/>
          <a:ext cx="5173560" cy="6178320"/>
        </p:xfrm>
        <a:graphic>
          <a:graphicData uri="http://schemas.openxmlformats.org/drawingml/2006/table">
            <a:tbl>
              <a:tblPr/>
              <a:tblGrid>
                <a:gridCol w="1238400"/>
                <a:gridCol w="1487520"/>
                <a:gridCol w="592200"/>
                <a:gridCol w="617400"/>
                <a:gridCol w="619200"/>
                <a:gridCol w="618840"/>
              </a:tblGrid>
              <a:tr h="372240">
                <a:tc gridSpan="5"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        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   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Rx140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0cece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0cece"/>
                    </a:solidFill>
                  </a:tcPr>
                </a:tc>
              </a:tr>
              <a:tr h="407160"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issue Genotypin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d0cece"/>
                    </a:solidFill>
                  </a:tcPr>
                </a:tc>
                <a:tc gridSpan="4"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tDNA Genotyping (MAF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d0cece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TC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Line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d0cece"/>
                    </a:solidFill>
                  </a:tcPr>
                </a:tc>
              </a:tr>
              <a:tr h="189720"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utatio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F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d0cece"/>
                    </a:solidFill>
                  </a:tcPr>
                </a:tc>
              </a:tr>
              <a:tr h="275760"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LK R1084C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LK R1084C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9720"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PC S331L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PC S331L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9720"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RID1A D1963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9720"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RID1A G838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.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9720"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RID1A E1006K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9720"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RID1A S662T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9720"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RID1A Q790Q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9720"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RID1A Y216f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.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27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9720"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RAF E695Q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9720"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RCA1 E1033Q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.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.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9720"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RCA1 E761K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9720"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RCA2 Q684K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45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9720"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RCA2 Q648K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9720"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RCA2 Q1138Q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9720"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RCA2 S3014L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9720"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RCA2 L709V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45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9720"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DH1 V391I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DH1 V391I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9720"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ERBB2 S310F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0.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0.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0.31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9720"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TOR D500H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9720"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OTCH1 E1567K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9720"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F1 E1790K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5760"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IK3CA E545K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IK3CA E545K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6120"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P53 R280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P53 R280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9720"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P53 S183*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9720"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P53 Splice site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9720"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SC1 E1106K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184" name="Rectangle 5"/>
          <p:cNvSpPr/>
          <p:nvPr/>
        </p:nvSpPr>
        <p:spPr>
          <a:xfrm>
            <a:off x="376200" y="8234280"/>
            <a:ext cx="10199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¶ Germline BRCA2 mutation was detected as part of genetic counseling for familial breast cancer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5" name="Rectangle 6"/>
          <p:cNvSpPr/>
          <p:nvPr/>
        </p:nvSpPr>
        <p:spPr>
          <a:xfrm>
            <a:off x="380880" y="8412120"/>
            <a:ext cx="2008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–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Insufficient Tumor tissue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6" name="Rectangle 8"/>
          <p:cNvSpPr/>
          <p:nvPr/>
        </p:nvSpPr>
        <p:spPr>
          <a:xfrm>
            <a:off x="368280" y="8867880"/>
            <a:ext cx="986940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††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ESR1 T1607C mutant allele frequency increased to 0.49 after prolonged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in vitro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culture under low-estrogen conditions (&gt;6 months)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BRx50 Tissue Genotyping and ctDNA Genotyping: not available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** Adapted from Yu et al. Science 201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187" name=""/>
          <p:cNvGraphicFramePr/>
          <p:nvPr/>
        </p:nvGraphicFramePr>
        <p:xfrm>
          <a:off x="6313320" y="1401840"/>
          <a:ext cx="2995920" cy="4592520"/>
        </p:xfrm>
        <a:graphic>
          <a:graphicData uri="http://schemas.openxmlformats.org/drawingml/2006/table">
            <a:tbl>
              <a:tblPr/>
              <a:tblGrid>
                <a:gridCol w="2346480"/>
                <a:gridCol w="649440"/>
              </a:tblGrid>
              <a:tr h="282600">
                <a:tc gridSpan="2"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Rx50 CTC Line **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bfbfb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479160"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utatio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F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bfbfbf"/>
                    </a:solidFill>
                  </a:tcPr>
                </a:tc>
              </a:tr>
              <a:tr h="201600"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DAMTSL3 R185P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4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1960"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RCA2¶ L2039f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–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1600"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IITA A5T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5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1600"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SR1 L536P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6†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1600"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ANCG  N167S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4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1600"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EV  W87*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5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1600"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FPGT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TNNI3K,TNNI3K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 A238T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4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1600"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PC3 R203C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1600"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GF2R R1580S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9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1600"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KZF1 G482C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1600"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RAK4 T9K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3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1600"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JAK3 R403C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4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1600"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LHL4 P419A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4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1600"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RP1B K1160R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4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1600"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COA1 P388H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5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1600"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OTCH2 P1421T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1600"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UP98 S1786R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4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1600"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LAG1 A376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4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1600"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IAM1 R23C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188" name="Rectangle 2"/>
          <p:cNvSpPr/>
          <p:nvPr/>
        </p:nvSpPr>
        <p:spPr>
          <a:xfrm>
            <a:off x="376200" y="8640720"/>
            <a:ext cx="6095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* Chain terminating codon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2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8-08-03T15:37:48Z</dcterms:created>
  <dc:creator>Dubash, Taronish Dorab</dc:creator>
  <dc:description/>
  <dc:language>en-US</dc:language>
  <cp:lastModifiedBy>Yasmin Esmaeili</cp:lastModifiedBy>
  <dcterms:modified xsi:type="dcterms:W3CDTF">2019-05-21T16:10:16Z</dcterms:modified>
  <cp:revision>58</cp:revision>
  <dc:subject/>
  <dc:title>PowerPoint Presentation</dc:title>
</cp:coreProperties>
</file>